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</p:sldIdLst>
  <p:sldSz cx="9144000" cy="6858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966E4DE-15C1-433C-AE21-171330E03C95}" v="34" dt="2023-08-25T15:52:04.45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B9631B5-78F2-41C9-869B-9F39066F8104}" styleName="Medium Style 3 - 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284E427A-3D55-4303-BF80-6455036E1DE7}" styleName="Themed Style 1 - Acc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18603FDC-E32A-4AB5-989C-0864C3EAD2B8}" styleName="Themed Style 2 - Accent 2">
    <a:tblBg>
      <a:fillRef idx="3">
        <a:schemeClr val="accent2"/>
      </a:fillRef>
      <a:effectRef idx="3">
        <a:schemeClr val="accent2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2">
                <a:tint val="50000"/>
              </a:schemeClr>
            </a:lnRef>
          </a:left>
          <a:right>
            <a:lnRef idx="1">
              <a:schemeClr val="accent2">
                <a:tint val="50000"/>
              </a:schemeClr>
            </a:lnRef>
          </a:right>
          <a:top>
            <a:lnRef idx="1">
              <a:schemeClr val="accent2">
                <a:tint val="50000"/>
              </a:schemeClr>
            </a:lnRef>
          </a:top>
          <a:bottom>
            <a:lnRef idx="1">
              <a:schemeClr val="accent2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E269D01E-BC32-4049-B463-5C60D7B0CCD2}" styleName="Themed Style 2 - Accent 4">
    <a:tblBg>
      <a:fillRef idx="3">
        <a:schemeClr val="accent4"/>
      </a:fillRef>
      <a:effectRef idx="3">
        <a:schemeClr val="accent4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4">
                <a:tint val="50000"/>
              </a:schemeClr>
            </a:lnRef>
          </a:left>
          <a:right>
            <a:lnRef idx="1">
              <a:schemeClr val="accent4">
                <a:tint val="50000"/>
              </a:schemeClr>
            </a:lnRef>
          </a:right>
          <a:top>
            <a:lnRef idx="1">
              <a:schemeClr val="accent4">
                <a:tint val="50000"/>
              </a:schemeClr>
            </a:lnRef>
          </a:top>
          <a:bottom>
            <a:lnRef idx="1">
              <a:schemeClr val="accent4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0E3FDE45-AF77-4B5C-9715-49D594BDF05E}" styleName="Light Style 1 - Acc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72833802-FEF1-4C79-8D5D-14CF1EAF98D9}" styleName="Light Style 2 - Accent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</a:tcStyle>
    </a:band1H>
    <a:band1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1V>
    <a:band2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2"/>
        </a:fillRef>
      </a:tcStyle>
    </a:firstRow>
  </a:tblStyle>
  <a:tblStyle styleId="{5DA37D80-6434-44D0-A028-1B22A696006F}" styleName="Light Style 3 - Accent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9DCAF9ED-07DC-4A11-8D7F-57B35C25682E}" styleName="Medium Style 1 - Accent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2">
              <a:tint val="20000"/>
            </a:schemeClr>
          </a:solidFill>
        </a:fill>
      </a:tcStyle>
    </a:band1H>
    <a:band1V>
      <a:tcStyle>
        <a:tcBdr/>
        <a:fill>
          <a:solidFill>
            <a:schemeClr val="accent2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20" autoAdjust="0"/>
    <p:restoredTop sz="94660"/>
  </p:normalViewPr>
  <p:slideViewPr>
    <p:cSldViewPr snapToGrid="0">
      <p:cViewPr varScale="1">
        <p:scale>
          <a:sx n="86" d="100"/>
          <a:sy n="86" d="100"/>
        </p:scale>
        <p:origin x="102" y="6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ian Luo" userId="1edd406c-00f7-4bf2-8bfe-6922e79acdd3" providerId="ADAL" clId="{FCDB8827-7DD8-4359-BFA2-80F0A3C37455}"/>
    <pc:docChg chg="undo custSel modSld">
      <pc:chgData name="Tian Luo" userId="1edd406c-00f7-4bf2-8bfe-6922e79acdd3" providerId="ADAL" clId="{FCDB8827-7DD8-4359-BFA2-80F0A3C37455}" dt="2023-08-24T06:17:39.754" v="73" actId="1035"/>
      <pc:docMkLst>
        <pc:docMk/>
      </pc:docMkLst>
      <pc:sldChg chg="modSp mod">
        <pc:chgData name="Tian Luo" userId="1edd406c-00f7-4bf2-8bfe-6922e79acdd3" providerId="ADAL" clId="{FCDB8827-7DD8-4359-BFA2-80F0A3C37455}" dt="2023-08-24T06:17:39.754" v="73" actId="1035"/>
        <pc:sldMkLst>
          <pc:docMk/>
          <pc:sldMk cId="2305308070" sldId="267"/>
        </pc:sldMkLst>
        <pc:spChg chg="mod">
          <ac:chgData name="Tian Luo" userId="1edd406c-00f7-4bf2-8bfe-6922e79acdd3" providerId="ADAL" clId="{FCDB8827-7DD8-4359-BFA2-80F0A3C37455}" dt="2023-08-24T06:17:39.754" v="73" actId="1035"/>
          <ac:spMkLst>
            <pc:docMk/>
            <pc:sldMk cId="2305308070" sldId="267"/>
            <ac:spMk id="3" creationId="{2849AAB7-539F-76F7-2C13-F0B2613BD31C}"/>
          </ac:spMkLst>
        </pc:spChg>
        <pc:spChg chg="mod ord">
          <ac:chgData name="Tian Luo" userId="1edd406c-00f7-4bf2-8bfe-6922e79acdd3" providerId="ADAL" clId="{FCDB8827-7DD8-4359-BFA2-80F0A3C37455}" dt="2023-08-24T05:09:44.910" v="18" actId="1038"/>
          <ac:spMkLst>
            <pc:docMk/>
            <pc:sldMk cId="2305308070" sldId="267"/>
            <ac:spMk id="112" creationId="{BEC27106-F78D-4604-A6BB-C6C4CC4A6823}"/>
          </ac:spMkLst>
        </pc:spChg>
        <pc:spChg chg="ord">
          <ac:chgData name="Tian Luo" userId="1edd406c-00f7-4bf2-8bfe-6922e79acdd3" providerId="ADAL" clId="{FCDB8827-7DD8-4359-BFA2-80F0A3C37455}" dt="2023-08-24T05:09:14.435" v="15" actId="166"/>
          <ac:spMkLst>
            <pc:docMk/>
            <pc:sldMk cId="2305308070" sldId="267"/>
            <ac:spMk id="125" creationId="{4D5E3AA6-3F56-42E2-9CE1-436E0A2BE276}"/>
          </ac:spMkLst>
        </pc:spChg>
        <pc:spChg chg="mod ord">
          <ac:chgData name="Tian Luo" userId="1edd406c-00f7-4bf2-8bfe-6922e79acdd3" providerId="ADAL" clId="{FCDB8827-7DD8-4359-BFA2-80F0A3C37455}" dt="2023-08-24T05:09:50.819" v="22" actId="1037"/>
          <ac:spMkLst>
            <pc:docMk/>
            <pc:sldMk cId="2305308070" sldId="267"/>
            <ac:spMk id="128" creationId="{8C841BDE-1505-4273-B3F3-2C010CBDF62F}"/>
          </ac:spMkLst>
        </pc:spChg>
        <pc:graphicFrameChg chg="mod modGraphic">
          <ac:chgData name="Tian Luo" userId="1edd406c-00f7-4bf2-8bfe-6922e79acdd3" providerId="ADAL" clId="{FCDB8827-7DD8-4359-BFA2-80F0A3C37455}" dt="2023-08-24T05:11:09.435" v="34" actId="14734"/>
          <ac:graphicFrameMkLst>
            <pc:docMk/>
            <pc:sldMk cId="2305308070" sldId="267"/>
            <ac:graphicFrameMk id="7" creationId="{5D15148F-2677-6492-B5D2-FCE73DC67E84}"/>
          </ac:graphicFrameMkLst>
        </pc:graphicFrameChg>
      </pc:sldChg>
    </pc:docChg>
  </pc:docChgLst>
  <pc:docChgLst>
    <pc:chgData name="Luo, Tian" userId="1edd406c-00f7-4bf2-8bfe-6922e79acdd3" providerId="ADAL" clId="{8966E4DE-15C1-433C-AE21-171330E03C95}"/>
    <pc:docChg chg="undo redo custSel addSld delSld modSld">
      <pc:chgData name="Luo, Tian" userId="1edd406c-00f7-4bf2-8bfe-6922e79acdd3" providerId="ADAL" clId="{8966E4DE-15C1-433C-AE21-171330E03C95}" dt="2023-08-25T15:53:06.721" v="1630" actId="20577"/>
      <pc:docMkLst>
        <pc:docMk/>
      </pc:docMkLst>
      <pc:sldChg chg="del">
        <pc:chgData name="Luo, Tian" userId="1edd406c-00f7-4bf2-8bfe-6922e79acdd3" providerId="ADAL" clId="{8966E4DE-15C1-433C-AE21-171330E03C95}" dt="2023-08-17T21:40:43.749" v="5" actId="47"/>
        <pc:sldMkLst>
          <pc:docMk/>
          <pc:sldMk cId="292316231" sldId="256"/>
        </pc:sldMkLst>
      </pc:sldChg>
      <pc:sldChg chg="del">
        <pc:chgData name="Luo, Tian" userId="1edd406c-00f7-4bf2-8bfe-6922e79acdd3" providerId="ADAL" clId="{8966E4DE-15C1-433C-AE21-171330E03C95}" dt="2023-08-17T21:40:40.643" v="0" actId="47"/>
        <pc:sldMkLst>
          <pc:docMk/>
          <pc:sldMk cId="2604460994" sldId="258"/>
        </pc:sldMkLst>
      </pc:sldChg>
      <pc:sldChg chg="addSp delSp modSp del mod">
        <pc:chgData name="Luo, Tian" userId="1edd406c-00f7-4bf2-8bfe-6922e79acdd3" providerId="ADAL" clId="{8966E4DE-15C1-433C-AE21-171330E03C95}" dt="2023-08-23T22:43:09.041" v="1588" actId="47"/>
        <pc:sldMkLst>
          <pc:docMk/>
          <pc:sldMk cId="1472455395" sldId="266"/>
        </pc:sldMkLst>
        <pc:spChg chg="mod">
          <ac:chgData name="Luo, Tian" userId="1edd406c-00f7-4bf2-8bfe-6922e79acdd3" providerId="ADAL" clId="{8966E4DE-15C1-433C-AE21-171330E03C95}" dt="2023-08-23T22:08:49.443" v="1109" actId="20577"/>
          <ac:spMkLst>
            <pc:docMk/>
            <pc:sldMk cId="1472455395" sldId="266"/>
            <ac:spMk id="2" creationId="{C9628456-E4FA-075B-47EE-6DAF43534945}"/>
          </ac:spMkLst>
        </pc:spChg>
        <pc:spChg chg="add mod">
          <ac:chgData name="Luo, Tian" userId="1edd406c-00f7-4bf2-8bfe-6922e79acdd3" providerId="ADAL" clId="{8966E4DE-15C1-433C-AE21-171330E03C95}" dt="2023-08-21T22:04:40.956" v="671" actId="114"/>
          <ac:spMkLst>
            <pc:docMk/>
            <pc:sldMk cId="1472455395" sldId="266"/>
            <ac:spMk id="3" creationId="{2849AAB7-539F-76F7-2C13-F0B2613BD31C}"/>
          </ac:spMkLst>
        </pc:spChg>
        <pc:spChg chg="add del mod">
          <ac:chgData name="Luo, Tian" userId="1edd406c-00f7-4bf2-8bfe-6922e79acdd3" providerId="ADAL" clId="{8966E4DE-15C1-433C-AE21-171330E03C95}" dt="2023-08-21T21:42:00.254" v="443" actId="478"/>
          <ac:spMkLst>
            <pc:docMk/>
            <pc:sldMk cId="1472455395" sldId="266"/>
            <ac:spMk id="4" creationId="{407D587F-8C4D-28A1-C82B-9A726905F849}"/>
          </ac:spMkLst>
        </pc:spChg>
        <pc:spChg chg="add mod">
          <ac:chgData name="Luo, Tian" userId="1edd406c-00f7-4bf2-8bfe-6922e79acdd3" providerId="ADAL" clId="{8966E4DE-15C1-433C-AE21-171330E03C95}" dt="2023-08-23T21:21:45.912" v="1063" actId="1038"/>
          <ac:spMkLst>
            <pc:docMk/>
            <pc:sldMk cId="1472455395" sldId="266"/>
            <ac:spMk id="5" creationId="{F7BF47BC-8D0E-1C3A-1DA4-E285B79FF711}"/>
          </ac:spMkLst>
        </pc:spChg>
        <pc:spChg chg="del">
          <ac:chgData name="Luo, Tian" userId="1edd406c-00f7-4bf2-8bfe-6922e79acdd3" providerId="ADAL" clId="{8966E4DE-15C1-433C-AE21-171330E03C95}" dt="2023-08-17T21:42:03.664" v="6" actId="478"/>
          <ac:spMkLst>
            <pc:docMk/>
            <pc:sldMk cId="1472455395" sldId="266"/>
            <ac:spMk id="6" creationId="{B317A2B7-22A7-4B59-BEEA-BB384C4857D4}"/>
          </ac:spMkLst>
        </pc:spChg>
        <pc:spChg chg="mod">
          <ac:chgData name="Luo, Tian" userId="1edd406c-00f7-4bf2-8bfe-6922e79acdd3" providerId="ADAL" clId="{8966E4DE-15C1-433C-AE21-171330E03C95}" dt="2023-08-23T21:21:45.912" v="1063" actId="1038"/>
          <ac:spMkLst>
            <pc:docMk/>
            <pc:sldMk cId="1472455395" sldId="266"/>
            <ac:spMk id="48" creationId="{0B612285-7C87-4592-BF7E-4180C77EAFC2}"/>
          </ac:spMkLst>
        </pc:spChg>
        <pc:spChg chg="mod">
          <ac:chgData name="Luo, Tian" userId="1edd406c-00f7-4bf2-8bfe-6922e79acdd3" providerId="ADAL" clId="{8966E4DE-15C1-433C-AE21-171330E03C95}" dt="2023-08-23T21:21:45.912" v="1063" actId="1038"/>
          <ac:spMkLst>
            <pc:docMk/>
            <pc:sldMk cId="1472455395" sldId="266"/>
            <ac:spMk id="81" creationId="{B0F64E31-DA27-4B24-93E5-5EA1A235CD41}"/>
          </ac:spMkLst>
        </pc:spChg>
        <pc:spChg chg="mod">
          <ac:chgData name="Luo, Tian" userId="1edd406c-00f7-4bf2-8bfe-6922e79acdd3" providerId="ADAL" clId="{8966E4DE-15C1-433C-AE21-171330E03C95}" dt="2023-08-23T21:21:45.912" v="1063" actId="1038"/>
          <ac:spMkLst>
            <pc:docMk/>
            <pc:sldMk cId="1472455395" sldId="266"/>
            <ac:spMk id="82" creationId="{0A2A23CC-C495-440E-A638-0491D887DF7C}"/>
          </ac:spMkLst>
        </pc:spChg>
        <pc:spChg chg="mod">
          <ac:chgData name="Luo, Tian" userId="1edd406c-00f7-4bf2-8bfe-6922e79acdd3" providerId="ADAL" clId="{8966E4DE-15C1-433C-AE21-171330E03C95}" dt="2023-08-23T21:21:45.912" v="1063" actId="1038"/>
          <ac:spMkLst>
            <pc:docMk/>
            <pc:sldMk cId="1472455395" sldId="266"/>
            <ac:spMk id="83" creationId="{D7B955A1-D18A-47AF-9E1A-BFBF57BB8CC8}"/>
          </ac:spMkLst>
        </pc:spChg>
        <pc:spChg chg="mod">
          <ac:chgData name="Luo, Tian" userId="1edd406c-00f7-4bf2-8bfe-6922e79acdd3" providerId="ADAL" clId="{8966E4DE-15C1-433C-AE21-171330E03C95}" dt="2023-08-23T21:21:45.912" v="1063" actId="1038"/>
          <ac:spMkLst>
            <pc:docMk/>
            <pc:sldMk cId="1472455395" sldId="266"/>
            <ac:spMk id="85" creationId="{2514B06E-B8AE-4B0B-BC41-FBE366508A8B}"/>
          </ac:spMkLst>
        </pc:spChg>
        <pc:spChg chg="mod">
          <ac:chgData name="Luo, Tian" userId="1edd406c-00f7-4bf2-8bfe-6922e79acdd3" providerId="ADAL" clId="{8966E4DE-15C1-433C-AE21-171330E03C95}" dt="2023-08-23T21:21:45.912" v="1063" actId="1038"/>
          <ac:spMkLst>
            <pc:docMk/>
            <pc:sldMk cId="1472455395" sldId="266"/>
            <ac:spMk id="93" creationId="{3FA53622-1A9A-4BB0-8AEB-B20352B15A63}"/>
          </ac:spMkLst>
        </pc:spChg>
        <pc:spChg chg="mod">
          <ac:chgData name="Luo, Tian" userId="1edd406c-00f7-4bf2-8bfe-6922e79acdd3" providerId="ADAL" clId="{8966E4DE-15C1-433C-AE21-171330E03C95}" dt="2023-08-23T21:21:45.912" v="1063" actId="1038"/>
          <ac:spMkLst>
            <pc:docMk/>
            <pc:sldMk cId="1472455395" sldId="266"/>
            <ac:spMk id="94" creationId="{8D98CAB8-8132-4957-9AE9-EB0DD7782BB2}"/>
          </ac:spMkLst>
        </pc:spChg>
        <pc:spChg chg="mod">
          <ac:chgData name="Luo, Tian" userId="1edd406c-00f7-4bf2-8bfe-6922e79acdd3" providerId="ADAL" clId="{8966E4DE-15C1-433C-AE21-171330E03C95}" dt="2023-08-23T21:21:45.912" v="1063" actId="1038"/>
          <ac:spMkLst>
            <pc:docMk/>
            <pc:sldMk cId="1472455395" sldId="266"/>
            <ac:spMk id="112" creationId="{BEC27106-F78D-4604-A6BB-C6C4CC4A6823}"/>
          </ac:spMkLst>
        </pc:spChg>
        <pc:spChg chg="mod">
          <ac:chgData name="Luo, Tian" userId="1edd406c-00f7-4bf2-8bfe-6922e79acdd3" providerId="ADAL" clId="{8966E4DE-15C1-433C-AE21-171330E03C95}" dt="2023-08-23T21:21:45.912" v="1063" actId="1038"/>
          <ac:spMkLst>
            <pc:docMk/>
            <pc:sldMk cId="1472455395" sldId="266"/>
            <ac:spMk id="113" creationId="{79BBA369-7246-46CD-9213-8A3CD65E5103}"/>
          </ac:spMkLst>
        </pc:spChg>
        <pc:spChg chg="mod">
          <ac:chgData name="Luo, Tian" userId="1edd406c-00f7-4bf2-8bfe-6922e79acdd3" providerId="ADAL" clId="{8966E4DE-15C1-433C-AE21-171330E03C95}" dt="2023-08-23T21:21:45.912" v="1063" actId="1038"/>
          <ac:spMkLst>
            <pc:docMk/>
            <pc:sldMk cId="1472455395" sldId="266"/>
            <ac:spMk id="114" creationId="{217662D8-6F45-408E-B3CE-56BE1ACF4D12}"/>
          </ac:spMkLst>
        </pc:spChg>
        <pc:spChg chg="mod">
          <ac:chgData name="Luo, Tian" userId="1edd406c-00f7-4bf2-8bfe-6922e79acdd3" providerId="ADAL" clId="{8966E4DE-15C1-433C-AE21-171330E03C95}" dt="2023-08-23T21:21:45.912" v="1063" actId="1038"/>
          <ac:spMkLst>
            <pc:docMk/>
            <pc:sldMk cId="1472455395" sldId="266"/>
            <ac:spMk id="115" creationId="{B326D09F-FAC0-44F8-B5F1-2FC4B269BEA5}"/>
          </ac:spMkLst>
        </pc:spChg>
        <pc:spChg chg="mod">
          <ac:chgData name="Luo, Tian" userId="1edd406c-00f7-4bf2-8bfe-6922e79acdd3" providerId="ADAL" clId="{8966E4DE-15C1-433C-AE21-171330E03C95}" dt="2023-08-23T21:21:45.912" v="1063" actId="1038"/>
          <ac:spMkLst>
            <pc:docMk/>
            <pc:sldMk cId="1472455395" sldId="266"/>
            <ac:spMk id="116" creationId="{6F3D16EE-CCD8-47D5-95BB-66A3349F3F66}"/>
          </ac:spMkLst>
        </pc:spChg>
        <pc:spChg chg="mod">
          <ac:chgData name="Luo, Tian" userId="1edd406c-00f7-4bf2-8bfe-6922e79acdd3" providerId="ADAL" clId="{8966E4DE-15C1-433C-AE21-171330E03C95}" dt="2023-08-23T21:21:45.912" v="1063" actId="1038"/>
          <ac:spMkLst>
            <pc:docMk/>
            <pc:sldMk cId="1472455395" sldId="266"/>
            <ac:spMk id="117" creationId="{3961382E-611B-48DD-8DBA-671648E48F21}"/>
          </ac:spMkLst>
        </pc:spChg>
        <pc:spChg chg="mod">
          <ac:chgData name="Luo, Tian" userId="1edd406c-00f7-4bf2-8bfe-6922e79acdd3" providerId="ADAL" clId="{8966E4DE-15C1-433C-AE21-171330E03C95}" dt="2023-08-23T21:21:45.912" v="1063" actId="1038"/>
          <ac:spMkLst>
            <pc:docMk/>
            <pc:sldMk cId="1472455395" sldId="266"/>
            <ac:spMk id="118" creationId="{85F9F6FA-55F4-400B-96F5-61FBE4D0A6C9}"/>
          </ac:spMkLst>
        </pc:spChg>
        <pc:spChg chg="mod">
          <ac:chgData name="Luo, Tian" userId="1edd406c-00f7-4bf2-8bfe-6922e79acdd3" providerId="ADAL" clId="{8966E4DE-15C1-433C-AE21-171330E03C95}" dt="2023-08-23T21:21:45.912" v="1063" actId="1038"/>
          <ac:spMkLst>
            <pc:docMk/>
            <pc:sldMk cId="1472455395" sldId="266"/>
            <ac:spMk id="120" creationId="{13F3150B-590D-4B0C-9E2E-E32F1E580267}"/>
          </ac:spMkLst>
        </pc:spChg>
        <pc:spChg chg="mod">
          <ac:chgData name="Luo, Tian" userId="1edd406c-00f7-4bf2-8bfe-6922e79acdd3" providerId="ADAL" clId="{8966E4DE-15C1-433C-AE21-171330E03C95}" dt="2023-08-23T21:21:45.912" v="1063" actId="1038"/>
          <ac:spMkLst>
            <pc:docMk/>
            <pc:sldMk cId="1472455395" sldId="266"/>
            <ac:spMk id="125" creationId="{4D5E3AA6-3F56-42E2-9CE1-436E0A2BE276}"/>
          </ac:spMkLst>
        </pc:spChg>
        <pc:spChg chg="mod">
          <ac:chgData name="Luo, Tian" userId="1edd406c-00f7-4bf2-8bfe-6922e79acdd3" providerId="ADAL" clId="{8966E4DE-15C1-433C-AE21-171330E03C95}" dt="2023-08-23T21:21:45.912" v="1063" actId="1038"/>
          <ac:spMkLst>
            <pc:docMk/>
            <pc:sldMk cId="1472455395" sldId="266"/>
            <ac:spMk id="128" creationId="{8C841BDE-1505-4273-B3F3-2C010CBDF62F}"/>
          </ac:spMkLst>
        </pc:spChg>
        <pc:spChg chg="del mod">
          <ac:chgData name="Luo, Tian" userId="1edd406c-00f7-4bf2-8bfe-6922e79acdd3" providerId="ADAL" clId="{8966E4DE-15C1-433C-AE21-171330E03C95}" dt="2023-08-21T21:46:22.436" v="494" actId="478"/>
          <ac:spMkLst>
            <pc:docMk/>
            <pc:sldMk cId="1472455395" sldId="266"/>
            <ac:spMk id="132" creationId="{7375EDD9-AFAD-4659-8652-6329F9153104}"/>
          </ac:spMkLst>
        </pc:spChg>
        <pc:cxnChg chg="mod">
          <ac:chgData name="Luo, Tian" userId="1edd406c-00f7-4bf2-8bfe-6922e79acdd3" providerId="ADAL" clId="{8966E4DE-15C1-433C-AE21-171330E03C95}" dt="2023-08-23T21:21:45.912" v="1063" actId="1038"/>
          <ac:cxnSpMkLst>
            <pc:docMk/>
            <pc:sldMk cId="1472455395" sldId="266"/>
            <ac:cxnSpMk id="89" creationId="{31632330-9545-4A1F-969D-A3BFD807085B}"/>
          </ac:cxnSpMkLst>
        </pc:cxnChg>
        <pc:cxnChg chg="mod">
          <ac:chgData name="Luo, Tian" userId="1edd406c-00f7-4bf2-8bfe-6922e79acdd3" providerId="ADAL" clId="{8966E4DE-15C1-433C-AE21-171330E03C95}" dt="2023-08-23T21:21:45.912" v="1063" actId="1038"/>
          <ac:cxnSpMkLst>
            <pc:docMk/>
            <pc:sldMk cId="1472455395" sldId="266"/>
            <ac:cxnSpMk id="90" creationId="{8F036F13-9B2B-4DC7-A0DC-867CA2BD9981}"/>
          </ac:cxnSpMkLst>
        </pc:cxnChg>
        <pc:cxnChg chg="mod">
          <ac:chgData name="Luo, Tian" userId="1edd406c-00f7-4bf2-8bfe-6922e79acdd3" providerId="ADAL" clId="{8966E4DE-15C1-433C-AE21-171330E03C95}" dt="2023-08-23T21:21:45.912" v="1063" actId="1038"/>
          <ac:cxnSpMkLst>
            <pc:docMk/>
            <pc:sldMk cId="1472455395" sldId="266"/>
            <ac:cxnSpMk id="92" creationId="{67DEEFD5-C1CD-4A9C-957D-043897A0BF1F}"/>
          </ac:cxnSpMkLst>
        </pc:cxnChg>
        <pc:cxnChg chg="mod">
          <ac:chgData name="Luo, Tian" userId="1edd406c-00f7-4bf2-8bfe-6922e79acdd3" providerId="ADAL" clId="{8966E4DE-15C1-433C-AE21-171330E03C95}" dt="2023-08-23T21:21:45.912" v="1063" actId="1038"/>
          <ac:cxnSpMkLst>
            <pc:docMk/>
            <pc:sldMk cId="1472455395" sldId="266"/>
            <ac:cxnSpMk id="95" creationId="{E5B79549-F8B9-4F65-B4FB-39E218929AC1}"/>
          </ac:cxnSpMkLst>
        </pc:cxnChg>
        <pc:cxnChg chg="mod">
          <ac:chgData name="Luo, Tian" userId="1edd406c-00f7-4bf2-8bfe-6922e79acdd3" providerId="ADAL" clId="{8966E4DE-15C1-433C-AE21-171330E03C95}" dt="2023-08-23T21:21:45.912" v="1063" actId="1038"/>
          <ac:cxnSpMkLst>
            <pc:docMk/>
            <pc:sldMk cId="1472455395" sldId="266"/>
            <ac:cxnSpMk id="96" creationId="{9BF1C958-6760-4BD2-8EA7-19418B2833D1}"/>
          </ac:cxnSpMkLst>
        </pc:cxnChg>
        <pc:cxnChg chg="mod">
          <ac:chgData name="Luo, Tian" userId="1edd406c-00f7-4bf2-8bfe-6922e79acdd3" providerId="ADAL" clId="{8966E4DE-15C1-433C-AE21-171330E03C95}" dt="2023-08-23T21:21:45.912" v="1063" actId="1038"/>
          <ac:cxnSpMkLst>
            <pc:docMk/>
            <pc:sldMk cId="1472455395" sldId="266"/>
            <ac:cxnSpMk id="97" creationId="{19FCD05C-EF26-4BA6-8263-A59150509AD6}"/>
          </ac:cxnSpMkLst>
        </pc:cxnChg>
        <pc:cxnChg chg="mod">
          <ac:chgData name="Luo, Tian" userId="1edd406c-00f7-4bf2-8bfe-6922e79acdd3" providerId="ADAL" clId="{8966E4DE-15C1-433C-AE21-171330E03C95}" dt="2023-08-23T21:21:45.912" v="1063" actId="1038"/>
          <ac:cxnSpMkLst>
            <pc:docMk/>
            <pc:sldMk cId="1472455395" sldId="266"/>
            <ac:cxnSpMk id="98" creationId="{53307706-64CC-48AC-B726-2918B950867A}"/>
          </ac:cxnSpMkLst>
        </pc:cxnChg>
        <pc:cxnChg chg="mod">
          <ac:chgData name="Luo, Tian" userId="1edd406c-00f7-4bf2-8bfe-6922e79acdd3" providerId="ADAL" clId="{8966E4DE-15C1-433C-AE21-171330E03C95}" dt="2023-08-23T21:21:45.912" v="1063" actId="1038"/>
          <ac:cxnSpMkLst>
            <pc:docMk/>
            <pc:sldMk cId="1472455395" sldId="266"/>
            <ac:cxnSpMk id="99" creationId="{A032D803-517A-410B-8D15-9626438E7F9C}"/>
          </ac:cxnSpMkLst>
        </pc:cxnChg>
        <pc:cxnChg chg="mod">
          <ac:chgData name="Luo, Tian" userId="1edd406c-00f7-4bf2-8bfe-6922e79acdd3" providerId="ADAL" clId="{8966E4DE-15C1-433C-AE21-171330E03C95}" dt="2023-08-23T21:21:45.912" v="1063" actId="1038"/>
          <ac:cxnSpMkLst>
            <pc:docMk/>
            <pc:sldMk cId="1472455395" sldId="266"/>
            <ac:cxnSpMk id="101" creationId="{7F7FF9E0-BE06-4B7A-893C-92AA3D6F78AA}"/>
          </ac:cxnSpMkLst>
        </pc:cxnChg>
        <pc:cxnChg chg="mod">
          <ac:chgData name="Luo, Tian" userId="1edd406c-00f7-4bf2-8bfe-6922e79acdd3" providerId="ADAL" clId="{8966E4DE-15C1-433C-AE21-171330E03C95}" dt="2023-08-23T21:21:45.912" v="1063" actId="1038"/>
          <ac:cxnSpMkLst>
            <pc:docMk/>
            <pc:sldMk cId="1472455395" sldId="266"/>
            <ac:cxnSpMk id="102" creationId="{56FA5C68-A569-4534-922D-FB2EEB461CFA}"/>
          </ac:cxnSpMkLst>
        </pc:cxnChg>
        <pc:cxnChg chg="mod">
          <ac:chgData name="Luo, Tian" userId="1edd406c-00f7-4bf2-8bfe-6922e79acdd3" providerId="ADAL" clId="{8966E4DE-15C1-433C-AE21-171330E03C95}" dt="2023-08-23T21:21:45.912" v="1063" actId="1038"/>
          <ac:cxnSpMkLst>
            <pc:docMk/>
            <pc:sldMk cId="1472455395" sldId="266"/>
            <ac:cxnSpMk id="104" creationId="{28F8C62A-CEE4-4E41-89EF-23A998ABF2F1}"/>
          </ac:cxnSpMkLst>
        </pc:cxnChg>
        <pc:cxnChg chg="mod">
          <ac:chgData name="Luo, Tian" userId="1edd406c-00f7-4bf2-8bfe-6922e79acdd3" providerId="ADAL" clId="{8966E4DE-15C1-433C-AE21-171330E03C95}" dt="2023-08-23T21:21:45.912" v="1063" actId="1038"/>
          <ac:cxnSpMkLst>
            <pc:docMk/>
            <pc:sldMk cId="1472455395" sldId="266"/>
            <ac:cxnSpMk id="105" creationId="{4749E31F-B104-416E-8A91-A13EE4B81436}"/>
          </ac:cxnSpMkLst>
        </pc:cxnChg>
        <pc:cxnChg chg="mod">
          <ac:chgData name="Luo, Tian" userId="1edd406c-00f7-4bf2-8bfe-6922e79acdd3" providerId="ADAL" clId="{8966E4DE-15C1-433C-AE21-171330E03C95}" dt="2023-08-23T21:21:45.912" v="1063" actId="1038"/>
          <ac:cxnSpMkLst>
            <pc:docMk/>
            <pc:sldMk cId="1472455395" sldId="266"/>
            <ac:cxnSpMk id="106" creationId="{1A2EE619-097D-4D99-AB25-59D5D45BBD0C}"/>
          </ac:cxnSpMkLst>
        </pc:cxnChg>
        <pc:cxnChg chg="mod">
          <ac:chgData name="Luo, Tian" userId="1edd406c-00f7-4bf2-8bfe-6922e79acdd3" providerId="ADAL" clId="{8966E4DE-15C1-433C-AE21-171330E03C95}" dt="2023-08-23T21:21:45.912" v="1063" actId="1038"/>
          <ac:cxnSpMkLst>
            <pc:docMk/>
            <pc:sldMk cId="1472455395" sldId="266"/>
            <ac:cxnSpMk id="107" creationId="{AEC41EBB-59B3-41D5-B47F-05246DA31045}"/>
          </ac:cxnSpMkLst>
        </pc:cxnChg>
        <pc:cxnChg chg="mod">
          <ac:chgData name="Luo, Tian" userId="1edd406c-00f7-4bf2-8bfe-6922e79acdd3" providerId="ADAL" clId="{8966E4DE-15C1-433C-AE21-171330E03C95}" dt="2023-08-23T21:21:45.912" v="1063" actId="1038"/>
          <ac:cxnSpMkLst>
            <pc:docMk/>
            <pc:sldMk cId="1472455395" sldId="266"/>
            <ac:cxnSpMk id="108" creationId="{197FC5EE-C2F5-4100-9AF6-9CA238965459}"/>
          </ac:cxnSpMkLst>
        </pc:cxnChg>
        <pc:cxnChg chg="mod">
          <ac:chgData name="Luo, Tian" userId="1edd406c-00f7-4bf2-8bfe-6922e79acdd3" providerId="ADAL" clId="{8966E4DE-15C1-433C-AE21-171330E03C95}" dt="2023-08-23T21:21:45.912" v="1063" actId="1038"/>
          <ac:cxnSpMkLst>
            <pc:docMk/>
            <pc:sldMk cId="1472455395" sldId="266"/>
            <ac:cxnSpMk id="127" creationId="{7C3DEBE0-B8A2-42FE-956C-32133AFF6C5B}"/>
          </ac:cxnSpMkLst>
        </pc:cxnChg>
      </pc:sldChg>
      <pc:sldChg chg="addSp delSp modSp add mod">
        <pc:chgData name="Luo, Tian" userId="1edd406c-00f7-4bf2-8bfe-6922e79acdd3" providerId="ADAL" clId="{8966E4DE-15C1-433C-AE21-171330E03C95}" dt="2023-08-25T15:53:06.721" v="1630" actId="20577"/>
        <pc:sldMkLst>
          <pc:docMk/>
          <pc:sldMk cId="2305308070" sldId="267"/>
        </pc:sldMkLst>
        <pc:spChg chg="del">
          <ac:chgData name="Luo, Tian" userId="1edd406c-00f7-4bf2-8bfe-6922e79acdd3" providerId="ADAL" clId="{8966E4DE-15C1-433C-AE21-171330E03C95}" dt="2023-08-23T22:14:23.386" v="1111" actId="478"/>
          <ac:spMkLst>
            <pc:docMk/>
            <pc:sldMk cId="2305308070" sldId="267"/>
            <ac:spMk id="2" creationId="{C9628456-E4FA-075B-47EE-6DAF43534945}"/>
          </ac:spMkLst>
        </pc:spChg>
        <pc:spChg chg="mod">
          <ac:chgData name="Luo, Tian" userId="1edd406c-00f7-4bf2-8bfe-6922e79acdd3" providerId="ADAL" clId="{8966E4DE-15C1-433C-AE21-171330E03C95}" dt="2023-08-23T22:35:51.949" v="1475" actId="114"/>
          <ac:spMkLst>
            <pc:docMk/>
            <pc:sldMk cId="2305308070" sldId="267"/>
            <ac:spMk id="3" creationId="{2849AAB7-539F-76F7-2C13-F0B2613BD31C}"/>
          </ac:spMkLst>
        </pc:spChg>
        <pc:spChg chg="del">
          <ac:chgData name="Luo, Tian" userId="1edd406c-00f7-4bf2-8bfe-6922e79acdd3" providerId="ADAL" clId="{8966E4DE-15C1-433C-AE21-171330E03C95}" dt="2023-08-23T22:14:23.386" v="1111" actId="478"/>
          <ac:spMkLst>
            <pc:docMk/>
            <pc:sldMk cId="2305308070" sldId="267"/>
            <ac:spMk id="5" creationId="{F7BF47BC-8D0E-1C3A-1DA4-E285B79FF711}"/>
          </ac:spMkLst>
        </pc:spChg>
        <pc:spChg chg="del">
          <ac:chgData name="Luo, Tian" userId="1edd406c-00f7-4bf2-8bfe-6922e79acdd3" providerId="ADAL" clId="{8966E4DE-15C1-433C-AE21-171330E03C95}" dt="2023-08-23T22:14:23.386" v="1111" actId="478"/>
          <ac:spMkLst>
            <pc:docMk/>
            <pc:sldMk cId="2305308070" sldId="267"/>
            <ac:spMk id="48" creationId="{0B612285-7C87-4592-BF7E-4180C77EAFC2}"/>
          </ac:spMkLst>
        </pc:spChg>
        <pc:spChg chg="mod">
          <ac:chgData name="Luo, Tian" userId="1edd406c-00f7-4bf2-8bfe-6922e79acdd3" providerId="ADAL" clId="{8966E4DE-15C1-433C-AE21-171330E03C95}" dt="2023-08-23T22:37:28.763" v="1526" actId="1038"/>
          <ac:spMkLst>
            <pc:docMk/>
            <pc:sldMk cId="2305308070" sldId="267"/>
            <ac:spMk id="81" creationId="{B0F64E31-DA27-4B24-93E5-5EA1A235CD41}"/>
          </ac:spMkLst>
        </pc:spChg>
        <pc:spChg chg="mod">
          <ac:chgData name="Luo, Tian" userId="1edd406c-00f7-4bf2-8bfe-6922e79acdd3" providerId="ADAL" clId="{8966E4DE-15C1-433C-AE21-171330E03C95}" dt="2023-08-23T22:37:28.763" v="1526" actId="1038"/>
          <ac:spMkLst>
            <pc:docMk/>
            <pc:sldMk cId="2305308070" sldId="267"/>
            <ac:spMk id="82" creationId="{0A2A23CC-C495-440E-A638-0491D887DF7C}"/>
          </ac:spMkLst>
        </pc:spChg>
        <pc:spChg chg="mod">
          <ac:chgData name="Luo, Tian" userId="1edd406c-00f7-4bf2-8bfe-6922e79acdd3" providerId="ADAL" clId="{8966E4DE-15C1-433C-AE21-171330E03C95}" dt="2023-08-23T22:37:28.763" v="1526" actId="1038"/>
          <ac:spMkLst>
            <pc:docMk/>
            <pc:sldMk cId="2305308070" sldId="267"/>
            <ac:spMk id="83" creationId="{D7B955A1-D18A-47AF-9E1A-BFBF57BB8CC8}"/>
          </ac:spMkLst>
        </pc:spChg>
        <pc:spChg chg="mod">
          <ac:chgData name="Luo, Tian" userId="1edd406c-00f7-4bf2-8bfe-6922e79acdd3" providerId="ADAL" clId="{8966E4DE-15C1-433C-AE21-171330E03C95}" dt="2023-08-23T22:37:28.763" v="1526" actId="1038"/>
          <ac:spMkLst>
            <pc:docMk/>
            <pc:sldMk cId="2305308070" sldId="267"/>
            <ac:spMk id="85" creationId="{2514B06E-B8AE-4B0B-BC41-FBE366508A8B}"/>
          </ac:spMkLst>
        </pc:spChg>
        <pc:spChg chg="mod">
          <ac:chgData name="Luo, Tian" userId="1edd406c-00f7-4bf2-8bfe-6922e79acdd3" providerId="ADAL" clId="{8966E4DE-15C1-433C-AE21-171330E03C95}" dt="2023-08-23T22:37:28.763" v="1526" actId="1038"/>
          <ac:spMkLst>
            <pc:docMk/>
            <pc:sldMk cId="2305308070" sldId="267"/>
            <ac:spMk id="93" creationId="{3FA53622-1A9A-4BB0-8AEB-B20352B15A63}"/>
          </ac:spMkLst>
        </pc:spChg>
        <pc:spChg chg="mod">
          <ac:chgData name="Luo, Tian" userId="1edd406c-00f7-4bf2-8bfe-6922e79acdd3" providerId="ADAL" clId="{8966E4DE-15C1-433C-AE21-171330E03C95}" dt="2023-08-23T22:37:28.763" v="1526" actId="1038"/>
          <ac:spMkLst>
            <pc:docMk/>
            <pc:sldMk cId="2305308070" sldId="267"/>
            <ac:spMk id="94" creationId="{8D98CAB8-8132-4957-9AE9-EB0DD7782BB2}"/>
          </ac:spMkLst>
        </pc:spChg>
        <pc:spChg chg="mod">
          <ac:chgData name="Luo, Tian" userId="1edd406c-00f7-4bf2-8bfe-6922e79acdd3" providerId="ADAL" clId="{8966E4DE-15C1-433C-AE21-171330E03C95}" dt="2023-08-23T22:37:28.763" v="1526" actId="1038"/>
          <ac:spMkLst>
            <pc:docMk/>
            <pc:sldMk cId="2305308070" sldId="267"/>
            <ac:spMk id="112" creationId="{BEC27106-F78D-4604-A6BB-C6C4CC4A6823}"/>
          </ac:spMkLst>
        </pc:spChg>
        <pc:spChg chg="mod">
          <ac:chgData name="Luo, Tian" userId="1edd406c-00f7-4bf2-8bfe-6922e79acdd3" providerId="ADAL" clId="{8966E4DE-15C1-433C-AE21-171330E03C95}" dt="2023-08-23T22:37:28.763" v="1526" actId="1038"/>
          <ac:spMkLst>
            <pc:docMk/>
            <pc:sldMk cId="2305308070" sldId="267"/>
            <ac:spMk id="113" creationId="{79BBA369-7246-46CD-9213-8A3CD65E5103}"/>
          </ac:spMkLst>
        </pc:spChg>
        <pc:spChg chg="mod">
          <ac:chgData name="Luo, Tian" userId="1edd406c-00f7-4bf2-8bfe-6922e79acdd3" providerId="ADAL" clId="{8966E4DE-15C1-433C-AE21-171330E03C95}" dt="2023-08-23T22:37:28.763" v="1526" actId="1038"/>
          <ac:spMkLst>
            <pc:docMk/>
            <pc:sldMk cId="2305308070" sldId="267"/>
            <ac:spMk id="114" creationId="{217662D8-6F45-408E-B3CE-56BE1ACF4D12}"/>
          </ac:spMkLst>
        </pc:spChg>
        <pc:spChg chg="mod">
          <ac:chgData name="Luo, Tian" userId="1edd406c-00f7-4bf2-8bfe-6922e79acdd3" providerId="ADAL" clId="{8966E4DE-15C1-433C-AE21-171330E03C95}" dt="2023-08-23T22:37:28.763" v="1526" actId="1038"/>
          <ac:spMkLst>
            <pc:docMk/>
            <pc:sldMk cId="2305308070" sldId="267"/>
            <ac:spMk id="115" creationId="{B326D09F-FAC0-44F8-B5F1-2FC4B269BEA5}"/>
          </ac:spMkLst>
        </pc:spChg>
        <pc:spChg chg="mod">
          <ac:chgData name="Luo, Tian" userId="1edd406c-00f7-4bf2-8bfe-6922e79acdd3" providerId="ADAL" clId="{8966E4DE-15C1-433C-AE21-171330E03C95}" dt="2023-08-23T22:37:28.763" v="1526" actId="1038"/>
          <ac:spMkLst>
            <pc:docMk/>
            <pc:sldMk cId="2305308070" sldId="267"/>
            <ac:spMk id="116" creationId="{6F3D16EE-CCD8-47D5-95BB-66A3349F3F66}"/>
          </ac:spMkLst>
        </pc:spChg>
        <pc:spChg chg="mod">
          <ac:chgData name="Luo, Tian" userId="1edd406c-00f7-4bf2-8bfe-6922e79acdd3" providerId="ADAL" clId="{8966E4DE-15C1-433C-AE21-171330E03C95}" dt="2023-08-23T22:37:28.763" v="1526" actId="1038"/>
          <ac:spMkLst>
            <pc:docMk/>
            <pc:sldMk cId="2305308070" sldId="267"/>
            <ac:spMk id="117" creationId="{3961382E-611B-48DD-8DBA-671648E48F21}"/>
          </ac:spMkLst>
        </pc:spChg>
        <pc:spChg chg="del">
          <ac:chgData name="Luo, Tian" userId="1edd406c-00f7-4bf2-8bfe-6922e79acdd3" providerId="ADAL" clId="{8966E4DE-15C1-433C-AE21-171330E03C95}" dt="2023-08-23T22:14:23.386" v="1111" actId="478"/>
          <ac:spMkLst>
            <pc:docMk/>
            <pc:sldMk cId="2305308070" sldId="267"/>
            <ac:spMk id="118" creationId="{85F9F6FA-55F4-400B-96F5-61FBE4D0A6C9}"/>
          </ac:spMkLst>
        </pc:spChg>
        <pc:spChg chg="del">
          <ac:chgData name="Luo, Tian" userId="1edd406c-00f7-4bf2-8bfe-6922e79acdd3" providerId="ADAL" clId="{8966E4DE-15C1-433C-AE21-171330E03C95}" dt="2023-08-23T22:14:23.386" v="1111" actId="478"/>
          <ac:spMkLst>
            <pc:docMk/>
            <pc:sldMk cId="2305308070" sldId="267"/>
            <ac:spMk id="120" creationId="{13F3150B-590D-4B0C-9E2E-E32F1E580267}"/>
          </ac:spMkLst>
        </pc:spChg>
        <pc:spChg chg="mod">
          <ac:chgData name="Luo, Tian" userId="1edd406c-00f7-4bf2-8bfe-6922e79acdd3" providerId="ADAL" clId="{8966E4DE-15C1-433C-AE21-171330E03C95}" dt="2023-08-23T22:37:28.763" v="1526" actId="1038"/>
          <ac:spMkLst>
            <pc:docMk/>
            <pc:sldMk cId="2305308070" sldId="267"/>
            <ac:spMk id="125" creationId="{4D5E3AA6-3F56-42E2-9CE1-436E0A2BE276}"/>
          </ac:spMkLst>
        </pc:spChg>
        <pc:spChg chg="mod">
          <ac:chgData name="Luo, Tian" userId="1edd406c-00f7-4bf2-8bfe-6922e79acdd3" providerId="ADAL" clId="{8966E4DE-15C1-433C-AE21-171330E03C95}" dt="2023-08-23T22:37:28.763" v="1526" actId="1038"/>
          <ac:spMkLst>
            <pc:docMk/>
            <pc:sldMk cId="2305308070" sldId="267"/>
            <ac:spMk id="128" creationId="{8C841BDE-1505-4273-B3F3-2C010CBDF62F}"/>
          </ac:spMkLst>
        </pc:spChg>
        <pc:graphicFrameChg chg="add del mod">
          <ac:chgData name="Luo, Tian" userId="1edd406c-00f7-4bf2-8bfe-6922e79acdd3" providerId="ADAL" clId="{8966E4DE-15C1-433C-AE21-171330E03C95}" dt="2023-08-23T22:15:09.797" v="1123"/>
          <ac:graphicFrameMkLst>
            <pc:docMk/>
            <pc:sldMk cId="2305308070" sldId="267"/>
            <ac:graphicFrameMk id="4" creationId="{ED4E6EDF-747D-C2F6-4B98-08C453BFC2AB}"/>
          </ac:graphicFrameMkLst>
        </pc:graphicFrameChg>
        <pc:graphicFrameChg chg="add del mod">
          <ac:chgData name="Luo, Tian" userId="1edd406c-00f7-4bf2-8bfe-6922e79acdd3" providerId="ADAL" clId="{8966E4DE-15C1-433C-AE21-171330E03C95}" dt="2023-08-23T22:15:36.494" v="1129"/>
          <ac:graphicFrameMkLst>
            <pc:docMk/>
            <pc:sldMk cId="2305308070" sldId="267"/>
            <ac:graphicFrameMk id="6" creationId="{2747B268-BC43-0030-1250-E7EB768A5122}"/>
          </ac:graphicFrameMkLst>
        </pc:graphicFrameChg>
        <pc:graphicFrameChg chg="add mod modGraphic">
          <ac:chgData name="Luo, Tian" userId="1edd406c-00f7-4bf2-8bfe-6922e79acdd3" providerId="ADAL" clId="{8966E4DE-15C1-433C-AE21-171330E03C95}" dt="2023-08-25T15:53:06.721" v="1630" actId="20577"/>
          <ac:graphicFrameMkLst>
            <pc:docMk/>
            <pc:sldMk cId="2305308070" sldId="267"/>
            <ac:graphicFrameMk id="7" creationId="{5D15148F-2677-6492-B5D2-FCE73DC67E84}"/>
          </ac:graphicFrameMkLst>
        </pc:graphicFrameChg>
        <pc:cxnChg chg="mod">
          <ac:chgData name="Luo, Tian" userId="1edd406c-00f7-4bf2-8bfe-6922e79acdd3" providerId="ADAL" clId="{8966E4DE-15C1-433C-AE21-171330E03C95}" dt="2023-08-23T22:37:28.763" v="1526" actId="1038"/>
          <ac:cxnSpMkLst>
            <pc:docMk/>
            <pc:sldMk cId="2305308070" sldId="267"/>
            <ac:cxnSpMk id="89" creationId="{31632330-9545-4A1F-969D-A3BFD807085B}"/>
          </ac:cxnSpMkLst>
        </pc:cxnChg>
        <pc:cxnChg chg="mod">
          <ac:chgData name="Luo, Tian" userId="1edd406c-00f7-4bf2-8bfe-6922e79acdd3" providerId="ADAL" clId="{8966E4DE-15C1-433C-AE21-171330E03C95}" dt="2023-08-23T22:37:28.763" v="1526" actId="1038"/>
          <ac:cxnSpMkLst>
            <pc:docMk/>
            <pc:sldMk cId="2305308070" sldId="267"/>
            <ac:cxnSpMk id="90" creationId="{8F036F13-9B2B-4DC7-A0DC-867CA2BD9981}"/>
          </ac:cxnSpMkLst>
        </pc:cxnChg>
        <pc:cxnChg chg="mod">
          <ac:chgData name="Luo, Tian" userId="1edd406c-00f7-4bf2-8bfe-6922e79acdd3" providerId="ADAL" clId="{8966E4DE-15C1-433C-AE21-171330E03C95}" dt="2023-08-23T22:37:28.763" v="1526" actId="1038"/>
          <ac:cxnSpMkLst>
            <pc:docMk/>
            <pc:sldMk cId="2305308070" sldId="267"/>
            <ac:cxnSpMk id="92" creationId="{67DEEFD5-C1CD-4A9C-957D-043897A0BF1F}"/>
          </ac:cxnSpMkLst>
        </pc:cxnChg>
        <pc:cxnChg chg="mod">
          <ac:chgData name="Luo, Tian" userId="1edd406c-00f7-4bf2-8bfe-6922e79acdd3" providerId="ADAL" clId="{8966E4DE-15C1-433C-AE21-171330E03C95}" dt="2023-08-23T22:37:28.763" v="1526" actId="1038"/>
          <ac:cxnSpMkLst>
            <pc:docMk/>
            <pc:sldMk cId="2305308070" sldId="267"/>
            <ac:cxnSpMk id="95" creationId="{E5B79549-F8B9-4F65-B4FB-39E218929AC1}"/>
          </ac:cxnSpMkLst>
        </pc:cxnChg>
        <pc:cxnChg chg="mod">
          <ac:chgData name="Luo, Tian" userId="1edd406c-00f7-4bf2-8bfe-6922e79acdd3" providerId="ADAL" clId="{8966E4DE-15C1-433C-AE21-171330E03C95}" dt="2023-08-23T22:37:28.763" v="1526" actId="1038"/>
          <ac:cxnSpMkLst>
            <pc:docMk/>
            <pc:sldMk cId="2305308070" sldId="267"/>
            <ac:cxnSpMk id="96" creationId="{9BF1C958-6760-4BD2-8EA7-19418B2833D1}"/>
          </ac:cxnSpMkLst>
        </pc:cxnChg>
        <pc:cxnChg chg="mod">
          <ac:chgData name="Luo, Tian" userId="1edd406c-00f7-4bf2-8bfe-6922e79acdd3" providerId="ADAL" clId="{8966E4DE-15C1-433C-AE21-171330E03C95}" dt="2023-08-23T22:37:28.763" v="1526" actId="1038"/>
          <ac:cxnSpMkLst>
            <pc:docMk/>
            <pc:sldMk cId="2305308070" sldId="267"/>
            <ac:cxnSpMk id="97" creationId="{19FCD05C-EF26-4BA6-8263-A59150509AD6}"/>
          </ac:cxnSpMkLst>
        </pc:cxnChg>
        <pc:cxnChg chg="mod">
          <ac:chgData name="Luo, Tian" userId="1edd406c-00f7-4bf2-8bfe-6922e79acdd3" providerId="ADAL" clId="{8966E4DE-15C1-433C-AE21-171330E03C95}" dt="2023-08-23T22:37:28.763" v="1526" actId="1038"/>
          <ac:cxnSpMkLst>
            <pc:docMk/>
            <pc:sldMk cId="2305308070" sldId="267"/>
            <ac:cxnSpMk id="98" creationId="{53307706-64CC-48AC-B726-2918B950867A}"/>
          </ac:cxnSpMkLst>
        </pc:cxnChg>
        <pc:cxnChg chg="mod">
          <ac:chgData name="Luo, Tian" userId="1edd406c-00f7-4bf2-8bfe-6922e79acdd3" providerId="ADAL" clId="{8966E4DE-15C1-433C-AE21-171330E03C95}" dt="2023-08-23T22:37:28.763" v="1526" actId="1038"/>
          <ac:cxnSpMkLst>
            <pc:docMk/>
            <pc:sldMk cId="2305308070" sldId="267"/>
            <ac:cxnSpMk id="99" creationId="{A032D803-517A-410B-8D15-9626438E7F9C}"/>
          </ac:cxnSpMkLst>
        </pc:cxnChg>
        <pc:cxnChg chg="mod">
          <ac:chgData name="Luo, Tian" userId="1edd406c-00f7-4bf2-8bfe-6922e79acdd3" providerId="ADAL" clId="{8966E4DE-15C1-433C-AE21-171330E03C95}" dt="2023-08-23T22:37:28.763" v="1526" actId="1038"/>
          <ac:cxnSpMkLst>
            <pc:docMk/>
            <pc:sldMk cId="2305308070" sldId="267"/>
            <ac:cxnSpMk id="101" creationId="{7F7FF9E0-BE06-4B7A-893C-92AA3D6F78AA}"/>
          </ac:cxnSpMkLst>
        </pc:cxnChg>
        <pc:cxnChg chg="mod">
          <ac:chgData name="Luo, Tian" userId="1edd406c-00f7-4bf2-8bfe-6922e79acdd3" providerId="ADAL" clId="{8966E4DE-15C1-433C-AE21-171330E03C95}" dt="2023-08-23T22:37:28.763" v="1526" actId="1038"/>
          <ac:cxnSpMkLst>
            <pc:docMk/>
            <pc:sldMk cId="2305308070" sldId="267"/>
            <ac:cxnSpMk id="102" creationId="{56FA5C68-A569-4534-922D-FB2EEB461CFA}"/>
          </ac:cxnSpMkLst>
        </pc:cxnChg>
        <pc:cxnChg chg="mod">
          <ac:chgData name="Luo, Tian" userId="1edd406c-00f7-4bf2-8bfe-6922e79acdd3" providerId="ADAL" clId="{8966E4DE-15C1-433C-AE21-171330E03C95}" dt="2023-08-23T22:37:28.763" v="1526" actId="1038"/>
          <ac:cxnSpMkLst>
            <pc:docMk/>
            <pc:sldMk cId="2305308070" sldId="267"/>
            <ac:cxnSpMk id="104" creationId="{28F8C62A-CEE4-4E41-89EF-23A998ABF2F1}"/>
          </ac:cxnSpMkLst>
        </pc:cxnChg>
        <pc:cxnChg chg="mod">
          <ac:chgData name="Luo, Tian" userId="1edd406c-00f7-4bf2-8bfe-6922e79acdd3" providerId="ADAL" clId="{8966E4DE-15C1-433C-AE21-171330E03C95}" dt="2023-08-23T22:37:28.763" v="1526" actId="1038"/>
          <ac:cxnSpMkLst>
            <pc:docMk/>
            <pc:sldMk cId="2305308070" sldId="267"/>
            <ac:cxnSpMk id="105" creationId="{4749E31F-B104-416E-8A91-A13EE4B81436}"/>
          </ac:cxnSpMkLst>
        </pc:cxnChg>
        <pc:cxnChg chg="mod">
          <ac:chgData name="Luo, Tian" userId="1edd406c-00f7-4bf2-8bfe-6922e79acdd3" providerId="ADAL" clId="{8966E4DE-15C1-433C-AE21-171330E03C95}" dt="2023-08-23T22:37:28.763" v="1526" actId="1038"/>
          <ac:cxnSpMkLst>
            <pc:docMk/>
            <pc:sldMk cId="2305308070" sldId="267"/>
            <ac:cxnSpMk id="106" creationId="{1A2EE619-097D-4D99-AB25-59D5D45BBD0C}"/>
          </ac:cxnSpMkLst>
        </pc:cxnChg>
        <pc:cxnChg chg="mod">
          <ac:chgData name="Luo, Tian" userId="1edd406c-00f7-4bf2-8bfe-6922e79acdd3" providerId="ADAL" clId="{8966E4DE-15C1-433C-AE21-171330E03C95}" dt="2023-08-23T22:37:28.763" v="1526" actId="1038"/>
          <ac:cxnSpMkLst>
            <pc:docMk/>
            <pc:sldMk cId="2305308070" sldId="267"/>
            <ac:cxnSpMk id="107" creationId="{AEC41EBB-59B3-41D5-B47F-05246DA31045}"/>
          </ac:cxnSpMkLst>
        </pc:cxnChg>
        <pc:cxnChg chg="mod">
          <ac:chgData name="Luo, Tian" userId="1edd406c-00f7-4bf2-8bfe-6922e79acdd3" providerId="ADAL" clId="{8966E4DE-15C1-433C-AE21-171330E03C95}" dt="2023-08-23T22:37:28.763" v="1526" actId="1038"/>
          <ac:cxnSpMkLst>
            <pc:docMk/>
            <pc:sldMk cId="2305308070" sldId="267"/>
            <ac:cxnSpMk id="108" creationId="{197FC5EE-C2F5-4100-9AF6-9CA238965459}"/>
          </ac:cxnSpMkLst>
        </pc:cxnChg>
        <pc:cxnChg chg="mod">
          <ac:chgData name="Luo, Tian" userId="1edd406c-00f7-4bf2-8bfe-6922e79acdd3" providerId="ADAL" clId="{8966E4DE-15C1-433C-AE21-171330E03C95}" dt="2023-08-23T22:37:28.763" v="1526" actId="1038"/>
          <ac:cxnSpMkLst>
            <pc:docMk/>
            <pc:sldMk cId="2305308070" sldId="267"/>
            <ac:cxnSpMk id="127" creationId="{7C3DEBE0-B8A2-42FE-956C-32133AFF6C5B}"/>
          </ac:cxnSpMkLst>
        </pc:cxnChg>
      </pc:sldChg>
      <pc:sldChg chg="del">
        <pc:chgData name="Luo, Tian" userId="1edd406c-00f7-4bf2-8bfe-6922e79acdd3" providerId="ADAL" clId="{8966E4DE-15C1-433C-AE21-171330E03C95}" dt="2023-08-17T21:40:42.410" v="4" actId="47"/>
        <pc:sldMkLst>
          <pc:docMk/>
          <pc:sldMk cId="456005553" sldId="274"/>
        </pc:sldMkLst>
      </pc:sldChg>
      <pc:sldChg chg="del">
        <pc:chgData name="Luo, Tian" userId="1edd406c-00f7-4bf2-8bfe-6922e79acdd3" providerId="ADAL" clId="{8966E4DE-15C1-433C-AE21-171330E03C95}" dt="2023-08-17T21:40:40.990" v="1" actId="47"/>
        <pc:sldMkLst>
          <pc:docMk/>
          <pc:sldMk cId="3769388107" sldId="298"/>
        </pc:sldMkLst>
      </pc:sldChg>
      <pc:sldChg chg="del">
        <pc:chgData name="Luo, Tian" userId="1edd406c-00f7-4bf2-8bfe-6922e79acdd3" providerId="ADAL" clId="{8966E4DE-15C1-433C-AE21-171330E03C95}" dt="2023-08-17T21:40:41.527" v="2" actId="47"/>
        <pc:sldMkLst>
          <pc:docMk/>
          <pc:sldMk cId="3041975896" sldId="299"/>
        </pc:sldMkLst>
      </pc:sldChg>
      <pc:sldChg chg="del">
        <pc:chgData name="Luo, Tian" userId="1edd406c-00f7-4bf2-8bfe-6922e79acdd3" providerId="ADAL" clId="{8966E4DE-15C1-433C-AE21-171330E03C95}" dt="2023-08-17T21:40:41.862" v="3" actId="47"/>
        <pc:sldMkLst>
          <pc:docMk/>
          <pc:sldMk cId="3622360047" sldId="300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CD39C-E702-4D99-97F4-4B0E495C3F7F}" type="datetimeFigureOut">
              <a:rPr lang="en-US" smtClean="0"/>
              <a:t>8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EA1317-B21F-42BC-9455-A03D2B743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89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CD39C-E702-4D99-97F4-4B0E495C3F7F}" type="datetimeFigureOut">
              <a:rPr lang="en-US" smtClean="0"/>
              <a:t>8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EA1317-B21F-42BC-9455-A03D2B743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81981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CD39C-E702-4D99-97F4-4B0E495C3F7F}" type="datetimeFigureOut">
              <a:rPr lang="en-US" smtClean="0"/>
              <a:t>8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EA1317-B21F-42BC-9455-A03D2B743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19521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CD39C-E702-4D99-97F4-4B0E495C3F7F}" type="datetimeFigureOut">
              <a:rPr lang="en-US" smtClean="0"/>
              <a:t>8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EA1317-B21F-42BC-9455-A03D2B743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62663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CD39C-E702-4D99-97F4-4B0E495C3F7F}" type="datetimeFigureOut">
              <a:rPr lang="en-US" smtClean="0"/>
              <a:t>8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EA1317-B21F-42BC-9455-A03D2B743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2639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CD39C-E702-4D99-97F4-4B0E495C3F7F}" type="datetimeFigureOut">
              <a:rPr lang="en-US" smtClean="0"/>
              <a:t>8/2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EA1317-B21F-42BC-9455-A03D2B743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63583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CD39C-E702-4D99-97F4-4B0E495C3F7F}" type="datetimeFigureOut">
              <a:rPr lang="en-US" smtClean="0"/>
              <a:t>8/24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EA1317-B21F-42BC-9455-A03D2B743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8409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CD39C-E702-4D99-97F4-4B0E495C3F7F}" type="datetimeFigureOut">
              <a:rPr lang="en-US" smtClean="0"/>
              <a:t>8/24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EA1317-B21F-42BC-9455-A03D2B743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64003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CD39C-E702-4D99-97F4-4B0E495C3F7F}" type="datetimeFigureOut">
              <a:rPr lang="en-US" smtClean="0"/>
              <a:t>8/24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EA1317-B21F-42BC-9455-A03D2B743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77712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CD39C-E702-4D99-97F4-4B0E495C3F7F}" type="datetimeFigureOut">
              <a:rPr lang="en-US" smtClean="0"/>
              <a:t>8/2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EA1317-B21F-42BC-9455-A03D2B743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9656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CD39C-E702-4D99-97F4-4B0E495C3F7F}" type="datetimeFigureOut">
              <a:rPr lang="en-US" smtClean="0"/>
              <a:t>8/2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EA1317-B21F-42BC-9455-A03D2B743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06137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6CD39C-E702-4D99-97F4-4B0E495C3F7F}" type="datetimeFigureOut">
              <a:rPr lang="en-US" smtClean="0"/>
              <a:t>8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EA1317-B21F-42BC-9455-A03D2B743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13717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TextBox 80">
            <a:extLst>
              <a:ext uri="{FF2B5EF4-FFF2-40B4-BE49-F238E27FC236}">
                <a16:creationId xmlns:a16="http://schemas.microsoft.com/office/drawing/2014/main" id="{B0F64E31-DA27-4B24-93E5-5EA1A235CD41}"/>
              </a:ext>
            </a:extLst>
          </p:cNvPr>
          <p:cNvSpPr txBox="1"/>
          <p:nvPr/>
        </p:nvSpPr>
        <p:spPr>
          <a:xfrm>
            <a:off x="3734701" y="298424"/>
            <a:ext cx="2519280" cy="276999"/>
          </a:xfrm>
          <a:prstGeom prst="rect">
            <a:avLst/>
          </a:prstGeom>
          <a:noFill/>
          <a:ln>
            <a:solidFill>
              <a:srgbClr val="FFFFFF">
                <a:lumMod val="65000"/>
              </a:srgbClr>
            </a:solidFill>
          </a:ln>
        </p:spPr>
        <p:txBody>
          <a:bodyPr wrap="none" lIns="45720" rIns="45720" anchor="ctr" anchorCtr="0">
            <a:spAutoFit/>
          </a:bodyPr>
          <a:lstStyle/>
          <a:p>
            <a:pPr marL="0" marR="0" lvl="0" indent="0" algn="ctr" defTabSz="91440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E. chaffeensi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E. canis</a:t>
            </a:r>
            <a:r>
              <a:rPr kumimoji="0" lang="en-US" sz="1200" i="1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ORFeomes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0A2A23CC-C495-440E-A638-0491D887DF7C}"/>
              </a:ext>
            </a:extLst>
          </p:cNvPr>
          <p:cNvSpPr txBox="1"/>
          <p:nvPr/>
        </p:nvSpPr>
        <p:spPr>
          <a:xfrm>
            <a:off x="3397210" y="1197308"/>
            <a:ext cx="799065" cy="276999"/>
          </a:xfrm>
          <a:prstGeom prst="rect">
            <a:avLst/>
          </a:prstGeom>
          <a:noFill/>
          <a:ln>
            <a:solidFill>
              <a:srgbClr val="FFFFFF">
                <a:lumMod val="65000"/>
              </a:srgbClr>
            </a:solidFill>
          </a:ln>
        </p:spPr>
        <p:txBody>
          <a:bodyPr wrap="none" lIns="45720" rIns="45720" anchor="ctr" anchorCtr="0">
            <a:spAutoFit/>
          </a:bodyPr>
          <a:lstStyle/>
          <a:p>
            <a:pPr marL="0" marR="0" lvl="0" indent="0" algn="ctr" defTabSz="91440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宋体" panose="02010600030101010101" pitchFamily="2" charset="-122"/>
              </a:rPr>
              <a:t>Top 1-250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D7B955A1-D18A-47AF-9E1A-BFBF57BB8CC8}"/>
              </a:ext>
            </a:extLst>
          </p:cNvPr>
          <p:cNvSpPr txBox="1"/>
          <p:nvPr/>
        </p:nvSpPr>
        <p:spPr>
          <a:xfrm>
            <a:off x="2883204" y="1987046"/>
            <a:ext cx="935513" cy="276999"/>
          </a:xfrm>
          <a:prstGeom prst="rect">
            <a:avLst/>
          </a:prstGeom>
          <a:noFill/>
          <a:ln>
            <a:solidFill>
              <a:srgbClr val="FFFFFF">
                <a:lumMod val="65000"/>
              </a:srgbClr>
            </a:solidFill>
          </a:ln>
        </p:spPr>
        <p:txBody>
          <a:bodyPr wrap="none" lIns="45720" rIns="45720" anchor="ctr" anchorCtr="0">
            <a:spAutoFit/>
          </a:bodyPr>
          <a:lstStyle/>
          <a:p>
            <a:pPr marL="0" marR="0" lvl="0" indent="0" defTabSz="91440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Arial"/>
                <a:ea typeface="宋体" panose="02010600030101010101" pitchFamily="2" charset="-122"/>
              </a:rPr>
              <a:t>Hypothetical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2514B06E-B8AE-4B0B-BC41-FBE366508A8B}"/>
              </a:ext>
            </a:extLst>
          </p:cNvPr>
          <p:cNvSpPr txBox="1"/>
          <p:nvPr/>
        </p:nvSpPr>
        <p:spPr>
          <a:xfrm>
            <a:off x="3856361" y="3035177"/>
            <a:ext cx="2224327" cy="276999"/>
          </a:xfrm>
          <a:prstGeom prst="rect">
            <a:avLst/>
          </a:prstGeom>
          <a:noFill/>
          <a:ln>
            <a:solidFill>
              <a:srgbClr val="FFFFFF">
                <a:lumMod val="65000"/>
              </a:srgbClr>
            </a:solidFill>
          </a:ln>
        </p:spPr>
        <p:txBody>
          <a:bodyPr wrap="none" lIns="45720" rIns="45720" anchor="ctr" anchorCtr="0">
            <a:spAutoFit/>
          </a:bodyPr>
          <a:lstStyle/>
          <a:p>
            <a:pPr marL="0" marR="0" lvl="0" indent="0" algn="ctr" defTabSz="91440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宋体" panose="02010600030101010101" pitchFamily="2" charset="-122"/>
              </a:rPr>
              <a:t>Immunoreactivity determination</a:t>
            </a:r>
          </a:p>
        </p:txBody>
      </p:sp>
      <p:cxnSp>
        <p:nvCxnSpPr>
          <p:cNvPr id="89" name="Straight Arrow Connector 88">
            <a:extLst>
              <a:ext uri="{FF2B5EF4-FFF2-40B4-BE49-F238E27FC236}">
                <a16:creationId xmlns:a16="http://schemas.microsoft.com/office/drawing/2014/main" id="{31632330-9545-4A1F-969D-A3BFD807085B}"/>
              </a:ext>
            </a:extLst>
          </p:cNvPr>
          <p:cNvCxnSpPr>
            <a:cxnSpLocks/>
          </p:cNvCxnSpPr>
          <p:nvPr/>
        </p:nvCxnSpPr>
        <p:spPr>
          <a:xfrm flipH="1">
            <a:off x="3871992" y="801402"/>
            <a:ext cx="1097280" cy="365047"/>
          </a:xfrm>
          <a:prstGeom prst="straightConnector1">
            <a:avLst/>
          </a:prstGeom>
          <a:noFill/>
          <a:ln w="9525" cap="flat" cmpd="sng" algn="ctr">
            <a:solidFill>
              <a:srgbClr val="FFFFFF">
                <a:lumMod val="50000"/>
              </a:srgbClr>
            </a:solidFill>
            <a:prstDash val="solid"/>
            <a:tailEnd type="triangle"/>
          </a:ln>
          <a:effectLst/>
        </p:spPr>
      </p:cxnSp>
      <p:cxnSp>
        <p:nvCxnSpPr>
          <p:cNvPr id="90" name="Straight Arrow Connector 89">
            <a:extLst>
              <a:ext uri="{FF2B5EF4-FFF2-40B4-BE49-F238E27FC236}">
                <a16:creationId xmlns:a16="http://schemas.microsoft.com/office/drawing/2014/main" id="{8F036F13-9B2B-4DC7-A0DC-867CA2BD9981}"/>
              </a:ext>
            </a:extLst>
          </p:cNvPr>
          <p:cNvCxnSpPr>
            <a:cxnSpLocks/>
          </p:cNvCxnSpPr>
          <p:nvPr/>
        </p:nvCxnSpPr>
        <p:spPr>
          <a:xfrm flipH="1">
            <a:off x="3537733" y="1609670"/>
            <a:ext cx="274320" cy="274320"/>
          </a:xfrm>
          <a:prstGeom prst="straightConnector1">
            <a:avLst/>
          </a:prstGeom>
          <a:noFill/>
          <a:ln w="9525" cap="flat" cmpd="sng" algn="ctr">
            <a:solidFill>
              <a:srgbClr val="0070C0"/>
            </a:solidFill>
            <a:prstDash val="solid"/>
            <a:tailEnd type="triangle"/>
          </a:ln>
          <a:effectLst/>
        </p:spPr>
      </p:cxnSp>
      <p:cxnSp>
        <p:nvCxnSpPr>
          <p:cNvPr id="92" name="Straight Arrow Connector 91">
            <a:extLst>
              <a:ext uri="{FF2B5EF4-FFF2-40B4-BE49-F238E27FC236}">
                <a16:creationId xmlns:a16="http://schemas.microsoft.com/office/drawing/2014/main" id="{67DEEFD5-C1CD-4A9C-957D-043897A0BF1F}"/>
              </a:ext>
            </a:extLst>
          </p:cNvPr>
          <p:cNvCxnSpPr>
            <a:cxnSpLocks/>
          </p:cNvCxnSpPr>
          <p:nvPr/>
        </p:nvCxnSpPr>
        <p:spPr>
          <a:xfrm flipH="1">
            <a:off x="5573217" y="2389092"/>
            <a:ext cx="731520" cy="457200"/>
          </a:xfrm>
          <a:prstGeom prst="straightConnector1">
            <a:avLst/>
          </a:prstGeom>
          <a:noFill/>
          <a:ln w="9525" cap="flat" cmpd="sng" algn="ctr">
            <a:solidFill>
              <a:srgbClr val="00B050"/>
            </a:solidFill>
            <a:prstDash val="solid"/>
            <a:tailEnd type="triangle"/>
          </a:ln>
          <a:effectLst/>
        </p:spPr>
      </p:cxnSp>
      <p:sp>
        <p:nvSpPr>
          <p:cNvPr id="93" name="Rectangle 92">
            <a:extLst>
              <a:ext uri="{FF2B5EF4-FFF2-40B4-BE49-F238E27FC236}">
                <a16:creationId xmlns:a16="http://schemas.microsoft.com/office/drawing/2014/main" id="{3FA53622-1A9A-4BB0-8AEB-B20352B15A63}"/>
              </a:ext>
            </a:extLst>
          </p:cNvPr>
          <p:cNvSpPr/>
          <p:nvPr/>
        </p:nvSpPr>
        <p:spPr>
          <a:xfrm>
            <a:off x="5035073" y="2363381"/>
            <a:ext cx="365760" cy="30777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defTabSz="914400" fontAlgn="base">
              <a:spcAft>
                <a:spcPct val="0"/>
              </a:spcAft>
            </a:pPr>
            <a:r>
              <a:rPr lang="en-US" sz="1000" dirty="0">
                <a:solidFill>
                  <a:srgbClr val="000000">
                    <a:lumMod val="65000"/>
                    <a:lumOff val="35000"/>
                  </a:srgbClr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IVTT</a:t>
            </a:r>
          </a:p>
          <a:p>
            <a:pPr algn="ctr" defTabSz="914400" fontAlgn="base">
              <a:spcAft>
                <a:spcPct val="0"/>
              </a:spcAft>
            </a:pPr>
            <a:r>
              <a:rPr lang="en-US" sz="1000" dirty="0">
                <a:solidFill>
                  <a:srgbClr val="000000">
                    <a:lumMod val="65000"/>
                    <a:lumOff val="35000"/>
                  </a:srgbClr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ELISA</a:t>
            </a:r>
          </a:p>
        </p:txBody>
      </p:sp>
      <p:sp>
        <p:nvSpPr>
          <p:cNvPr id="94" name="Rectangle 93">
            <a:extLst>
              <a:ext uri="{FF2B5EF4-FFF2-40B4-BE49-F238E27FC236}">
                <a16:creationId xmlns:a16="http://schemas.microsoft.com/office/drawing/2014/main" id="{8D98CAB8-8132-4957-9AE9-EB0DD7782BB2}"/>
              </a:ext>
            </a:extLst>
          </p:cNvPr>
          <p:cNvSpPr/>
          <p:nvPr/>
        </p:nvSpPr>
        <p:spPr>
          <a:xfrm>
            <a:off x="4967983" y="628012"/>
            <a:ext cx="960120" cy="253916"/>
          </a:xfrm>
          <a:prstGeom prst="rect">
            <a:avLst/>
          </a:prstGeom>
        </p:spPr>
        <p:txBody>
          <a:bodyPr wrap="square" anchor="ctr" anchorCtr="0">
            <a:spAutoFit/>
          </a:bodyPr>
          <a:lstStyle/>
          <a:p>
            <a:pPr algn="ctr" defTabSz="914400" fontAlgn="base">
              <a:spcBef>
                <a:spcPct val="50000"/>
              </a:spcBef>
              <a:spcAft>
                <a:spcPct val="0"/>
              </a:spcAft>
            </a:pPr>
            <a:r>
              <a:rPr lang="en-US" sz="1000" dirty="0">
                <a:solidFill>
                  <a:srgbClr val="000000">
                    <a:lumMod val="65000"/>
                    <a:lumOff val="35000"/>
                  </a:srgbClr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ANTIGENpro</a:t>
            </a:r>
          </a:p>
        </p:txBody>
      </p:sp>
      <p:cxnSp>
        <p:nvCxnSpPr>
          <p:cNvPr id="95" name="Straight Arrow Connector 94">
            <a:extLst>
              <a:ext uri="{FF2B5EF4-FFF2-40B4-BE49-F238E27FC236}">
                <a16:creationId xmlns:a16="http://schemas.microsoft.com/office/drawing/2014/main" id="{E5B79549-F8B9-4F65-B4FB-39E218929AC1}"/>
              </a:ext>
            </a:extLst>
          </p:cNvPr>
          <p:cNvCxnSpPr>
            <a:cxnSpLocks/>
          </p:cNvCxnSpPr>
          <p:nvPr/>
        </p:nvCxnSpPr>
        <p:spPr>
          <a:xfrm flipH="1">
            <a:off x="4050375" y="3423091"/>
            <a:ext cx="731520" cy="365760"/>
          </a:xfrm>
          <a:prstGeom prst="straightConnector1">
            <a:avLst/>
          </a:prstGeom>
          <a:noFill/>
          <a:ln w="9525" cap="flat" cmpd="sng" algn="ctr">
            <a:solidFill>
              <a:srgbClr val="0070C0"/>
            </a:solidFill>
            <a:prstDash val="solid"/>
            <a:tailEnd type="triangle"/>
          </a:ln>
          <a:effectLst/>
        </p:spPr>
      </p:cxnSp>
      <p:cxnSp>
        <p:nvCxnSpPr>
          <p:cNvPr id="96" name="Straight Arrow Connector 95">
            <a:extLst>
              <a:ext uri="{FF2B5EF4-FFF2-40B4-BE49-F238E27FC236}">
                <a16:creationId xmlns:a16="http://schemas.microsoft.com/office/drawing/2014/main" id="{9BF1C958-6760-4BD2-8EA7-19418B2833D1}"/>
              </a:ext>
            </a:extLst>
          </p:cNvPr>
          <p:cNvCxnSpPr>
            <a:cxnSpLocks/>
          </p:cNvCxnSpPr>
          <p:nvPr/>
        </p:nvCxnSpPr>
        <p:spPr>
          <a:xfrm flipH="1">
            <a:off x="5233532" y="2409198"/>
            <a:ext cx="365760" cy="457200"/>
          </a:xfrm>
          <a:prstGeom prst="straightConnector1">
            <a:avLst/>
          </a:prstGeom>
          <a:noFill/>
          <a:ln w="9525" cap="flat" cmpd="sng" algn="ctr">
            <a:solidFill>
              <a:srgbClr val="FF0000"/>
            </a:solidFill>
            <a:prstDash val="solid"/>
            <a:tailEnd type="triangle"/>
          </a:ln>
          <a:effectLst/>
        </p:spPr>
      </p:cxnSp>
      <p:cxnSp>
        <p:nvCxnSpPr>
          <p:cNvPr id="97" name="Straight Arrow Connector 96">
            <a:extLst>
              <a:ext uri="{FF2B5EF4-FFF2-40B4-BE49-F238E27FC236}">
                <a16:creationId xmlns:a16="http://schemas.microsoft.com/office/drawing/2014/main" id="{19FCD05C-EF26-4BA6-8263-A59150509AD6}"/>
              </a:ext>
            </a:extLst>
          </p:cNvPr>
          <p:cNvCxnSpPr>
            <a:cxnSpLocks/>
          </p:cNvCxnSpPr>
          <p:nvPr/>
        </p:nvCxnSpPr>
        <p:spPr>
          <a:xfrm>
            <a:off x="3822141" y="1609670"/>
            <a:ext cx="274320" cy="274320"/>
          </a:xfrm>
          <a:prstGeom prst="straightConnector1">
            <a:avLst/>
          </a:prstGeom>
          <a:noFill/>
          <a:ln w="9525" cap="flat" cmpd="sng" algn="ctr">
            <a:solidFill>
              <a:srgbClr val="FF0000"/>
            </a:solidFill>
            <a:prstDash val="solid"/>
            <a:tailEnd type="triangle"/>
          </a:ln>
          <a:effectLst/>
        </p:spPr>
      </p:cxnSp>
      <p:cxnSp>
        <p:nvCxnSpPr>
          <p:cNvPr id="98" name="Straight Arrow Connector 97">
            <a:extLst>
              <a:ext uri="{FF2B5EF4-FFF2-40B4-BE49-F238E27FC236}">
                <a16:creationId xmlns:a16="http://schemas.microsoft.com/office/drawing/2014/main" id="{53307706-64CC-48AC-B726-2918B950867A}"/>
              </a:ext>
            </a:extLst>
          </p:cNvPr>
          <p:cNvCxnSpPr>
            <a:cxnSpLocks/>
          </p:cNvCxnSpPr>
          <p:nvPr/>
        </p:nvCxnSpPr>
        <p:spPr>
          <a:xfrm>
            <a:off x="3709790" y="2406456"/>
            <a:ext cx="731520" cy="457200"/>
          </a:xfrm>
          <a:prstGeom prst="straightConnector1">
            <a:avLst/>
          </a:prstGeom>
          <a:noFill/>
          <a:ln w="9525" cap="flat" cmpd="sng" algn="ctr">
            <a:solidFill>
              <a:srgbClr val="0070C0"/>
            </a:solidFill>
            <a:prstDash val="solid"/>
            <a:tailEnd type="triangle"/>
          </a:ln>
          <a:effectLst/>
        </p:spPr>
      </p:cxnSp>
      <p:cxnSp>
        <p:nvCxnSpPr>
          <p:cNvPr id="99" name="Straight Arrow Connector 98">
            <a:extLst>
              <a:ext uri="{FF2B5EF4-FFF2-40B4-BE49-F238E27FC236}">
                <a16:creationId xmlns:a16="http://schemas.microsoft.com/office/drawing/2014/main" id="{A032D803-517A-410B-8D15-9626438E7F9C}"/>
              </a:ext>
            </a:extLst>
          </p:cNvPr>
          <p:cNvCxnSpPr>
            <a:cxnSpLocks/>
          </p:cNvCxnSpPr>
          <p:nvPr/>
        </p:nvCxnSpPr>
        <p:spPr>
          <a:xfrm>
            <a:off x="5147313" y="3413947"/>
            <a:ext cx="731520" cy="365760"/>
          </a:xfrm>
          <a:prstGeom prst="straightConnector1">
            <a:avLst/>
          </a:prstGeom>
          <a:noFill/>
          <a:ln w="9525" cap="flat" cmpd="sng" algn="ctr">
            <a:solidFill>
              <a:srgbClr val="00B050"/>
            </a:solidFill>
            <a:prstDash val="solid"/>
            <a:tailEnd type="triangle"/>
          </a:ln>
          <a:effectLst/>
        </p:spPr>
      </p:cxnSp>
      <p:cxnSp>
        <p:nvCxnSpPr>
          <p:cNvPr id="101" name="Straight Arrow Connector 100">
            <a:extLst>
              <a:ext uri="{FF2B5EF4-FFF2-40B4-BE49-F238E27FC236}">
                <a16:creationId xmlns:a16="http://schemas.microsoft.com/office/drawing/2014/main" id="{7F7FF9E0-BE06-4B7A-893C-92AA3D6F78AA}"/>
              </a:ext>
            </a:extLst>
          </p:cNvPr>
          <p:cNvCxnSpPr>
            <a:cxnSpLocks/>
          </p:cNvCxnSpPr>
          <p:nvPr/>
        </p:nvCxnSpPr>
        <p:spPr>
          <a:xfrm>
            <a:off x="6147343" y="1605403"/>
            <a:ext cx="274320" cy="274320"/>
          </a:xfrm>
          <a:prstGeom prst="straightConnector1">
            <a:avLst/>
          </a:prstGeom>
          <a:noFill/>
          <a:ln w="9525" cap="flat" cmpd="sng" algn="ctr">
            <a:solidFill>
              <a:srgbClr val="00B050"/>
            </a:solidFill>
            <a:prstDash val="solid"/>
            <a:tailEnd type="triangle"/>
          </a:ln>
          <a:effectLst/>
        </p:spPr>
      </p:cxnSp>
      <p:cxnSp>
        <p:nvCxnSpPr>
          <p:cNvPr id="102" name="Straight Arrow Connector 101">
            <a:extLst>
              <a:ext uri="{FF2B5EF4-FFF2-40B4-BE49-F238E27FC236}">
                <a16:creationId xmlns:a16="http://schemas.microsoft.com/office/drawing/2014/main" id="{56FA5C68-A569-4534-922D-FB2EEB461CFA}"/>
              </a:ext>
            </a:extLst>
          </p:cNvPr>
          <p:cNvCxnSpPr>
            <a:cxnSpLocks/>
          </p:cNvCxnSpPr>
          <p:nvPr/>
        </p:nvCxnSpPr>
        <p:spPr>
          <a:xfrm flipH="1">
            <a:off x="4974207" y="792845"/>
            <a:ext cx="0" cy="365760"/>
          </a:xfrm>
          <a:prstGeom prst="straightConnector1">
            <a:avLst/>
          </a:prstGeom>
          <a:noFill/>
          <a:ln w="9525" cap="flat" cmpd="sng" algn="ctr">
            <a:solidFill>
              <a:srgbClr val="FFFFFF">
                <a:lumMod val="50000"/>
              </a:srgbClr>
            </a:solidFill>
            <a:prstDash val="solid"/>
            <a:tailEnd type="triangle"/>
          </a:ln>
          <a:effectLst/>
        </p:spPr>
      </p:cxnSp>
      <p:cxnSp>
        <p:nvCxnSpPr>
          <p:cNvPr id="104" name="Straight Arrow Connector 103">
            <a:extLst>
              <a:ext uri="{FF2B5EF4-FFF2-40B4-BE49-F238E27FC236}">
                <a16:creationId xmlns:a16="http://schemas.microsoft.com/office/drawing/2014/main" id="{28F8C62A-CEE4-4E41-89EF-23A998ABF2F1}"/>
              </a:ext>
            </a:extLst>
          </p:cNvPr>
          <p:cNvCxnSpPr>
            <a:cxnSpLocks/>
          </p:cNvCxnSpPr>
          <p:nvPr/>
        </p:nvCxnSpPr>
        <p:spPr>
          <a:xfrm flipH="1">
            <a:off x="4975023" y="1616291"/>
            <a:ext cx="0" cy="1280160"/>
          </a:xfrm>
          <a:prstGeom prst="straightConnector1">
            <a:avLst/>
          </a:prstGeom>
          <a:noFill/>
          <a:ln w="9525" cap="flat" cmpd="sng" algn="ctr">
            <a:solidFill>
              <a:srgbClr val="FF0000"/>
            </a:solidFill>
            <a:prstDash val="solid"/>
            <a:tailEnd type="triangle"/>
          </a:ln>
          <a:effectLst/>
        </p:spPr>
      </p:cxnSp>
      <p:cxnSp>
        <p:nvCxnSpPr>
          <p:cNvPr id="105" name="Straight Arrow Connector 104">
            <a:extLst>
              <a:ext uri="{FF2B5EF4-FFF2-40B4-BE49-F238E27FC236}">
                <a16:creationId xmlns:a16="http://schemas.microsoft.com/office/drawing/2014/main" id="{4749E31F-B104-416E-8A91-A13EE4B81436}"/>
              </a:ext>
            </a:extLst>
          </p:cNvPr>
          <p:cNvCxnSpPr>
            <a:cxnSpLocks/>
          </p:cNvCxnSpPr>
          <p:nvPr/>
        </p:nvCxnSpPr>
        <p:spPr>
          <a:xfrm flipH="1">
            <a:off x="5860007" y="1605403"/>
            <a:ext cx="274320" cy="274320"/>
          </a:xfrm>
          <a:prstGeom prst="straightConnector1">
            <a:avLst/>
          </a:prstGeom>
          <a:noFill/>
          <a:ln w="9525" cap="flat" cmpd="sng" algn="ctr">
            <a:solidFill>
              <a:srgbClr val="FF0000"/>
            </a:solidFill>
            <a:prstDash val="solid"/>
            <a:tailEnd type="triangle"/>
          </a:ln>
          <a:effectLst/>
        </p:spPr>
      </p:cxnSp>
      <p:cxnSp>
        <p:nvCxnSpPr>
          <p:cNvPr id="106" name="Straight Arrow Connector 105">
            <a:extLst>
              <a:ext uri="{FF2B5EF4-FFF2-40B4-BE49-F238E27FC236}">
                <a16:creationId xmlns:a16="http://schemas.microsoft.com/office/drawing/2014/main" id="{1A2EE619-097D-4D99-AB25-59D5D45BBD0C}"/>
              </a:ext>
            </a:extLst>
          </p:cNvPr>
          <p:cNvCxnSpPr>
            <a:cxnSpLocks/>
          </p:cNvCxnSpPr>
          <p:nvPr/>
        </p:nvCxnSpPr>
        <p:spPr>
          <a:xfrm>
            <a:off x="4419744" y="2406456"/>
            <a:ext cx="365760" cy="457200"/>
          </a:xfrm>
          <a:prstGeom prst="straightConnector1">
            <a:avLst/>
          </a:prstGeom>
          <a:noFill/>
          <a:ln w="9525" cap="flat" cmpd="sng" algn="ctr">
            <a:solidFill>
              <a:srgbClr val="FF0000"/>
            </a:solidFill>
            <a:prstDash val="solid"/>
            <a:tailEnd type="triangle"/>
          </a:ln>
          <a:effectLst/>
        </p:spPr>
      </p:cxnSp>
      <p:cxnSp>
        <p:nvCxnSpPr>
          <p:cNvPr id="107" name="Straight Arrow Connector 106">
            <a:extLst>
              <a:ext uri="{FF2B5EF4-FFF2-40B4-BE49-F238E27FC236}">
                <a16:creationId xmlns:a16="http://schemas.microsoft.com/office/drawing/2014/main" id="{AEC41EBB-59B3-41D5-B47F-05246DA31045}"/>
              </a:ext>
            </a:extLst>
          </p:cNvPr>
          <p:cNvCxnSpPr>
            <a:cxnSpLocks/>
          </p:cNvCxnSpPr>
          <p:nvPr/>
        </p:nvCxnSpPr>
        <p:spPr>
          <a:xfrm>
            <a:off x="4970803" y="801402"/>
            <a:ext cx="1097280" cy="365760"/>
          </a:xfrm>
          <a:prstGeom prst="straightConnector1">
            <a:avLst/>
          </a:prstGeom>
          <a:noFill/>
          <a:ln w="9525" cap="flat" cmpd="sng" algn="ctr">
            <a:solidFill>
              <a:srgbClr val="FFFFFF">
                <a:lumMod val="50000"/>
              </a:srgbClr>
            </a:solidFill>
            <a:prstDash val="solid"/>
            <a:tailEnd type="triangle"/>
          </a:ln>
          <a:effectLst/>
        </p:spPr>
      </p:cxnSp>
      <p:cxnSp>
        <p:nvCxnSpPr>
          <p:cNvPr id="108" name="Straight Connector 107">
            <a:extLst>
              <a:ext uri="{FF2B5EF4-FFF2-40B4-BE49-F238E27FC236}">
                <a16:creationId xmlns:a16="http://schemas.microsoft.com/office/drawing/2014/main" id="{197FC5EE-C2F5-4100-9AF6-9CA238965459}"/>
              </a:ext>
            </a:extLst>
          </p:cNvPr>
          <p:cNvCxnSpPr/>
          <p:nvPr/>
        </p:nvCxnSpPr>
        <p:spPr>
          <a:xfrm>
            <a:off x="4970461" y="598784"/>
            <a:ext cx="0" cy="182880"/>
          </a:xfrm>
          <a:prstGeom prst="line">
            <a:avLst/>
          </a:prstGeom>
          <a:noFill/>
          <a:ln w="9525" cap="flat" cmpd="sng" algn="ctr">
            <a:solidFill>
              <a:srgbClr val="FFFFFF">
                <a:lumMod val="50000"/>
              </a:srgbClr>
            </a:solidFill>
            <a:prstDash val="solid"/>
          </a:ln>
          <a:effectLst/>
        </p:spPr>
      </p:cxnSp>
      <p:sp>
        <p:nvSpPr>
          <p:cNvPr id="113" name="TextBox 112">
            <a:extLst>
              <a:ext uri="{FF2B5EF4-FFF2-40B4-BE49-F238E27FC236}">
                <a16:creationId xmlns:a16="http://schemas.microsoft.com/office/drawing/2014/main" id="{79BBA369-7246-46CD-9213-8A3CD65E5103}"/>
              </a:ext>
            </a:extLst>
          </p:cNvPr>
          <p:cNvSpPr txBox="1"/>
          <p:nvPr/>
        </p:nvSpPr>
        <p:spPr>
          <a:xfrm>
            <a:off x="3965118" y="1987046"/>
            <a:ext cx="791242" cy="276999"/>
          </a:xfrm>
          <a:prstGeom prst="rect">
            <a:avLst/>
          </a:prstGeom>
          <a:noFill/>
          <a:ln>
            <a:solidFill>
              <a:srgbClr val="FFFFFF">
                <a:lumMod val="65000"/>
              </a:srgbClr>
            </a:solidFill>
          </a:ln>
        </p:spPr>
        <p:txBody>
          <a:bodyPr wrap="none" lIns="45720" rIns="45720" anchor="ctr" anchorCtr="0">
            <a:spAutoFit/>
          </a:bodyPr>
          <a:lstStyle/>
          <a:p>
            <a:pPr marL="0" marR="0" lvl="0" indent="0" defTabSz="91440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/>
                <a:ea typeface="宋体" panose="02010600030101010101" pitchFamily="2" charset="-122"/>
              </a:rPr>
              <a:t>Annotated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217662D8-6F45-408E-B3CE-56BE1ACF4D12}"/>
              </a:ext>
            </a:extLst>
          </p:cNvPr>
          <p:cNvSpPr txBox="1"/>
          <p:nvPr/>
        </p:nvSpPr>
        <p:spPr>
          <a:xfrm>
            <a:off x="5156702" y="1987046"/>
            <a:ext cx="935513" cy="276999"/>
          </a:xfrm>
          <a:prstGeom prst="rect">
            <a:avLst/>
          </a:prstGeom>
          <a:noFill/>
          <a:ln>
            <a:solidFill>
              <a:srgbClr val="FFFFFF">
                <a:lumMod val="65000"/>
              </a:srgbClr>
            </a:solidFill>
          </a:ln>
        </p:spPr>
        <p:txBody>
          <a:bodyPr wrap="none" lIns="45720" rIns="45720" anchor="ctr" anchorCtr="0">
            <a:spAutoFit/>
          </a:bodyPr>
          <a:lstStyle/>
          <a:p>
            <a:pPr marL="0" marR="0" lvl="0" indent="0" defTabSz="91440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/>
                <a:ea typeface="宋体" panose="02010600030101010101" pitchFamily="2" charset="-122"/>
              </a:rPr>
              <a:t>Hypothetical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B326D09F-FAC0-44F8-B5F1-2FC4B269BEA5}"/>
              </a:ext>
            </a:extLst>
          </p:cNvPr>
          <p:cNvSpPr txBox="1"/>
          <p:nvPr/>
        </p:nvSpPr>
        <p:spPr>
          <a:xfrm>
            <a:off x="6255166" y="1987046"/>
            <a:ext cx="791242" cy="276999"/>
          </a:xfrm>
          <a:prstGeom prst="rect">
            <a:avLst/>
          </a:prstGeom>
          <a:noFill/>
          <a:ln>
            <a:solidFill>
              <a:srgbClr val="FFFFFF">
                <a:lumMod val="65000"/>
              </a:srgbClr>
            </a:solidFill>
          </a:ln>
        </p:spPr>
        <p:txBody>
          <a:bodyPr wrap="none" lIns="45720" rIns="45720" anchor="ctr" anchorCtr="0">
            <a:spAutoFit/>
          </a:bodyPr>
          <a:lstStyle/>
          <a:p>
            <a:pPr marL="0" marR="0" lvl="0" indent="0" defTabSz="91440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i="0" u="none" strike="noStrike" kern="0" cap="none" spc="0" normalizeH="0" baseline="0" noProof="0" dirty="0">
                <a:ln>
                  <a:noFill/>
                </a:ln>
                <a:solidFill>
                  <a:srgbClr val="00B050"/>
                </a:solidFill>
                <a:effectLst/>
                <a:uLnTx/>
                <a:uFillTx/>
                <a:latin typeface="Arial"/>
                <a:ea typeface="宋体" panose="02010600030101010101" pitchFamily="2" charset="-122"/>
              </a:rPr>
              <a:t>Annotated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6F3D16EE-CCD8-47D5-95BB-66A3349F3F66}"/>
              </a:ext>
            </a:extLst>
          </p:cNvPr>
          <p:cNvSpPr txBox="1"/>
          <p:nvPr/>
        </p:nvSpPr>
        <p:spPr>
          <a:xfrm>
            <a:off x="4667098" y="1197308"/>
            <a:ext cx="653384" cy="276999"/>
          </a:xfrm>
          <a:prstGeom prst="rect">
            <a:avLst/>
          </a:prstGeom>
          <a:noFill/>
          <a:ln>
            <a:solidFill>
              <a:srgbClr val="FFFFFF">
                <a:lumMod val="65000"/>
              </a:srgbClr>
            </a:solidFill>
          </a:ln>
        </p:spPr>
        <p:txBody>
          <a:bodyPr wrap="none" lIns="45720" rIns="45720" anchor="ctr" anchorCtr="0">
            <a:spAutoFit/>
          </a:bodyPr>
          <a:lstStyle/>
          <a:p>
            <a:pPr marL="0" marR="0" lvl="0" indent="0" algn="ctr" defTabSz="91440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宋体" panose="02010600030101010101" pitchFamily="2" charset="-122"/>
              </a:rPr>
              <a:t>251-350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3961382E-611B-48DD-8DBA-671648E48F21}"/>
              </a:ext>
            </a:extLst>
          </p:cNvPr>
          <p:cNvSpPr txBox="1"/>
          <p:nvPr/>
        </p:nvSpPr>
        <p:spPr>
          <a:xfrm>
            <a:off x="5717401" y="1197308"/>
            <a:ext cx="824906" cy="276999"/>
          </a:xfrm>
          <a:prstGeom prst="rect">
            <a:avLst/>
          </a:prstGeom>
          <a:noFill/>
          <a:ln>
            <a:solidFill>
              <a:srgbClr val="FFFFFF">
                <a:lumMod val="65000"/>
              </a:srgbClr>
            </a:solidFill>
          </a:ln>
        </p:spPr>
        <p:txBody>
          <a:bodyPr wrap="none" lIns="45720" rIns="45720" anchor="ctr" anchorCtr="0">
            <a:spAutoFit/>
          </a:bodyPr>
          <a:lstStyle/>
          <a:p>
            <a:pPr marL="0" marR="0" lvl="0" indent="0" algn="r" defTabSz="91440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宋体" panose="02010600030101010101" pitchFamily="2" charset="-122"/>
              </a:rPr>
              <a:t>351-others</a:t>
            </a:r>
          </a:p>
        </p:txBody>
      </p:sp>
      <p:cxnSp>
        <p:nvCxnSpPr>
          <p:cNvPr id="127" name="Straight Arrow Connector 126">
            <a:extLst>
              <a:ext uri="{FF2B5EF4-FFF2-40B4-BE49-F238E27FC236}">
                <a16:creationId xmlns:a16="http://schemas.microsoft.com/office/drawing/2014/main" id="{7C3DEBE0-B8A2-42FE-956C-32133AFF6C5B}"/>
              </a:ext>
            </a:extLst>
          </p:cNvPr>
          <p:cNvCxnSpPr>
            <a:cxnSpLocks/>
          </p:cNvCxnSpPr>
          <p:nvPr/>
        </p:nvCxnSpPr>
        <p:spPr>
          <a:xfrm>
            <a:off x="4975023" y="3440504"/>
            <a:ext cx="0" cy="365760"/>
          </a:xfrm>
          <a:prstGeom prst="straightConnector1">
            <a:avLst/>
          </a:prstGeom>
          <a:noFill/>
          <a:ln w="9525" cap="flat" cmpd="sng" algn="ctr">
            <a:solidFill>
              <a:srgbClr val="FF0000"/>
            </a:solidFill>
            <a:prstDash val="solid"/>
            <a:tailEnd type="triangle"/>
          </a:ln>
          <a:effectLst/>
        </p:spPr>
      </p:cxn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49AAB7-539F-76F7-2C13-F0B2613BD31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19927" y="6094207"/>
            <a:ext cx="7786126" cy="631653"/>
          </a:xfrm>
        </p:spPr>
        <p:txBody>
          <a:bodyPr/>
          <a:lstStyle/>
          <a:p>
            <a:pPr marL="0" indent="0">
              <a:buNone/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ure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1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schematic diagram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chaffeensi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cani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munome project showing our identification strategy and the numbers of identified proteins in this study (green) and our previous publications (blue and red) (Luo T, et al. 2020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PJ Vaccine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, 85; Luo T, et al. 2021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fect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9, e0022421).</a:t>
            </a: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5D15148F-2677-6492-B5D2-FCE73DC67E8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44836376"/>
              </p:ext>
            </p:extLst>
          </p:nvPr>
        </p:nvGraphicFramePr>
        <p:xfrm>
          <a:off x="827772" y="4330907"/>
          <a:ext cx="7642461" cy="135197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010517">
                  <a:extLst>
                    <a:ext uri="{9D8B030D-6E8A-4147-A177-3AD203B41FA5}">
                      <a16:colId xmlns:a16="http://schemas.microsoft.com/office/drawing/2014/main" val="3235410026"/>
                    </a:ext>
                  </a:extLst>
                </a:gridCol>
                <a:gridCol w="1300574">
                  <a:extLst>
                    <a:ext uri="{9D8B030D-6E8A-4147-A177-3AD203B41FA5}">
                      <a16:colId xmlns:a16="http://schemas.microsoft.com/office/drawing/2014/main" val="3739314182"/>
                    </a:ext>
                  </a:extLst>
                </a:gridCol>
                <a:gridCol w="1665171">
                  <a:extLst>
                    <a:ext uri="{9D8B030D-6E8A-4147-A177-3AD203B41FA5}">
                      <a16:colId xmlns:a16="http://schemas.microsoft.com/office/drawing/2014/main" val="3912672741"/>
                    </a:ext>
                  </a:extLst>
                </a:gridCol>
                <a:gridCol w="1289884">
                  <a:extLst>
                    <a:ext uri="{9D8B030D-6E8A-4147-A177-3AD203B41FA5}">
                      <a16:colId xmlns:a16="http://schemas.microsoft.com/office/drawing/2014/main" val="4162730258"/>
                    </a:ext>
                  </a:extLst>
                </a:gridCol>
                <a:gridCol w="1376315">
                  <a:extLst>
                    <a:ext uri="{9D8B030D-6E8A-4147-A177-3AD203B41FA5}">
                      <a16:colId xmlns:a16="http://schemas.microsoft.com/office/drawing/2014/main" val="3725856100"/>
                    </a:ext>
                  </a:extLst>
                </a:gridCol>
              </a:tblGrid>
              <a:tr h="223467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Proteins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 (</a:t>
                      </a:r>
                      <a:r>
                        <a:rPr lang="en-US" sz="1050" b="1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.ch</a:t>
                      </a:r>
                      <a:r>
                        <a:rPr lang="en-US" sz="105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050" b="1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.ca</a:t>
                      </a:r>
                      <a:r>
                        <a:rPr lang="en-US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050" b="1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 (</a:t>
                      </a:r>
                      <a:r>
                        <a:rPr lang="en-US" sz="1050" b="1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.ch</a:t>
                      </a:r>
                      <a:r>
                        <a:rPr lang="en-US" sz="105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050" b="1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.ca</a:t>
                      </a:r>
                      <a:r>
                        <a:rPr lang="en-US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050" b="1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 (</a:t>
                      </a:r>
                      <a:r>
                        <a:rPr lang="en-US" sz="1050" b="1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.ch</a:t>
                      </a:r>
                      <a:r>
                        <a:rPr lang="en-US" sz="105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050" b="1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.ca</a:t>
                      </a:r>
                      <a:r>
                        <a:rPr lang="en-US" sz="105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050" b="1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No. (</a:t>
                      </a:r>
                      <a:r>
                        <a:rPr lang="en-US" sz="1050" b="1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  <a:r>
                        <a:rPr lang="en-US" sz="1050" b="1" i="1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ch</a:t>
                      </a:r>
                      <a:r>
                        <a:rPr lang="en-US" sz="1050" b="1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050" b="1" i="1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  <a:r>
                        <a:rPr lang="en-US" sz="1050" b="1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ca</a:t>
                      </a:r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050" b="1" i="0" u="none" strike="noStrike" dirty="0">
                        <a:solidFill>
                          <a:srgbClr val="0070C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82460354"/>
                  </a:ext>
                </a:extLst>
              </a:tr>
              <a:tr h="225702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vestigated: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 / 98</a:t>
                      </a:r>
                      <a:endParaRPr lang="en-US" sz="1050" b="0" i="0" u="none" strike="noStrike" dirty="0">
                        <a:solidFill>
                          <a:srgbClr val="0070C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0 / 314</a:t>
                      </a:r>
                      <a:endParaRPr lang="en-US" sz="105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444 / 405</a:t>
                      </a:r>
                      <a:endParaRPr lang="en-US" sz="1050" b="0" i="0" u="none" strike="noStrike" dirty="0">
                        <a:solidFill>
                          <a:srgbClr val="00B05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7 / 817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04989121"/>
                  </a:ext>
                </a:extLst>
              </a:tr>
              <a:tr h="225702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unoreactive (total):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8 / 30  </a:t>
                      </a:r>
                      <a:endParaRPr lang="en-US" sz="1050" b="0" i="0" u="none" strike="noStrike" dirty="0">
                        <a:solidFill>
                          <a:srgbClr val="0070C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           68 / 39</a:t>
                      </a:r>
                      <a:endParaRPr lang="en-US" sz="105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u="none" strike="noStrike" dirty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     196 / 43</a:t>
                      </a:r>
                      <a:endParaRPr lang="en-US" sz="1050" b="0" i="0" u="none" strike="noStrike" dirty="0">
                        <a:solidFill>
                          <a:srgbClr val="00B05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2 / 112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68976200"/>
                  </a:ext>
                </a:extLst>
              </a:tr>
              <a:tr h="225702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Immunoreactive (OD=0.2~0.5):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2 / 18</a:t>
                      </a:r>
                      <a:endParaRPr lang="en-US" sz="1050" b="0" i="0" u="none" strike="noStrike" dirty="0">
                        <a:solidFill>
                          <a:srgbClr val="0070C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           46 / 21</a:t>
                      </a:r>
                      <a:endParaRPr lang="en-US" sz="105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u="none" strike="noStrike" dirty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     140 / 39</a:t>
                      </a:r>
                      <a:endParaRPr lang="en-US" sz="1050" b="0" i="0" u="none" strike="noStrike" dirty="0">
                        <a:solidFill>
                          <a:srgbClr val="00B05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     188 / 78 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337584938"/>
                  </a:ext>
                </a:extLst>
              </a:tr>
              <a:tr h="225702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Subdominant (OD=0.5~1.0):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        3 / 4</a:t>
                      </a:r>
                      <a:endParaRPr lang="en-US" sz="1050" b="0" i="0" u="none" strike="noStrike" dirty="0">
                        <a:solidFill>
                          <a:srgbClr val="0070C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           18 / 9</a:t>
                      </a:r>
                      <a:endParaRPr lang="en-US" sz="105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u="none" strike="noStrike" dirty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       49 / 3</a:t>
                      </a:r>
                      <a:endParaRPr lang="en-US" sz="1050" b="0" i="0" u="none" strike="noStrike" dirty="0">
                        <a:solidFill>
                          <a:srgbClr val="00B05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 / 16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940766243"/>
                  </a:ext>
                </a:extLst>
              </a:tr>
              <a:tr h="225702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Immunodominant (OD&gt;1.0):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        3 / 8</a:t>
                      </a:r>
                      <a:endParaRPr lang="en-US" sz="1050" b="0" i="0" u="none" strike="noStrike" dirty="0">
                        <a:solidFill>
                          <a:srgbClr val="0070C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5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             4 / 9</a:t>
                      </a:r>
                      <a:endParaRPr lang="en-US" sz="105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/ 1</a:t>
                      </a:r>
                      <a:endParaRPr lang="en-US" sz="1050" b="0" i="0" u="none" strike="noStrike" dirty="0">
                        <a:solidFill>
                          <a:srgbClr val="00B05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 / 18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394308695"/>
                  </a:ext>
                </a:extLst>
              </a:tr>
            </a:tbl>
          </a:graphicData>
        </a:graphic>
      </p:graphicFrame>
      <p:sp>
        <p:nvSpPr>
          <p:cNvPr id="112" name="TextBox 111">
            <a:extLst>
              <a:ext uri="{FF2B5EF4-FFF2-40B4-BE49-F238E27FC236}">
                <a16:creationId xmlns:a16="http://schemas.microsoft.com/office/drawing/2014/main" id="{BEC27106-F78D-4604-A6BB-C6C4CC4A6823}"/>
              </a:ext>
            </a:extLst>
          </p:cNvPr>
          <p:cNvSpPr txBox="1"/>
          <p:nvPr/>
        </p:nvSpPr>
        <p:spPr>
          <a:xfrm>
            <a:off x="2836336" y="3914989"/>
            <a:ext cx="1280160" cy="406265"/>
          </a:xfrm>
          <a:prstGeom prst="rect">
            <a:avLst/>
          </a:prstGeom>
          <a:noFill/>
          <a:ln>
            <a:solidFill>
              <a:srgbClr val="FFFFFF">
                <a:lumMod val="65000"/>
              </a:srgbClr>
            </a:solidFill>
          </a:ln>
        </p:spPr>
        <p:txBody>
          <a:bodyPr wrap="none" lIns="45720" tIns="18288" rIns="45720" bIns="18288" anchor="ctr" anchorCtr="0">
            <a:spAutoFit/>
          </a:bodyPr>
          <a:lstStyle/>
          <a:p>
            <a:pPr marL="3143250" marR="0" lvl="0" indent="-314325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Arial"/>
                <a:ea typeface="宋体" panose="02010600030101010101" pitchFamily="2" charset="-122"/>
              </a:rPr>
              <a:t>NPJ Vaccines</a:t>
            </a:r>
          </a:p>
          <a:p>
            <a:pPr marL="3143250" marR="0" lvl="0" indent="-314325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Arial"/>
                <a:ea typeface="宋体" panose="02010600030101010101" pitchFamily="2" charset="-122"/>
              </a:rPr>
              <a:t>2020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4D5E3AA6-3F56-42E2-9CE1-436E0A2BE276}"/>
              </a:ext>
            </a:extLst>
          </p:cNvPr>
          <p:cNvSpPr txBox="1"/>
          <p:nvPr/>
        </p:nvSpPr>
        <p:spPr>
          <a:xfrm>
            <a:off x="4147725" y="3914989"/>
            <a:ext cx="1637629" cy="406265"/>
          </a:xfrm>
          <a:prstGeom prst="rect">
            <a:avLst/>
          </a:prstGeom>
          <a:noFill/>
          <a:ln>
            <a:solidFill>
              <a:srgbClr val="FFFFFF">
                <a:lumMod val="65000"/>
              </a:srgbClr>
            </a:solidFill>
          </a:ln>
        </p:spPr>
        <p:txBody>
          <a:bodyPr wrap="none" lIns="45720" tIns="18288" rIns="45720" bIns="18288" anchor="ctr" anchorCtr="0">
            <a:spAutoFit/>
          </a:bodyPr>
          <a:lstStyle/>
          <a:p>
            <a:pPr marL="3143250" marR="0" lvl="0" indent="-314325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/>
                <a:ea typeface="宋体" panose="02010600030101010101" pitchFamily="2" charset="-122"/>
              </a:rPr>
              <a:t>Infection and Immunity</a:t>
            </a:r>
          </a:p>
          <a:p>
            <a:pPr marL="3143250" marR="0" lvl="0" indent="-314325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/>
                <a:ea typeface="宋体" panose="02010600030101010101" pitchFamily="2" charset="-122"/>
              </a:rPr>
              <a:t>2021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8C841BDE-1505-4273-B3F3-2C010CBDF62F}"/>
              </a:ext>
            </a:extLst>
          </p:cNvPr>
          <p:cNvSpPr txBox="1"/>
          <p:nvPr/>
        </p:nvSpPr>
        <p:spPr>
          <a:xfrm>
            <a:off x="5810724" y="3914989"/>
            <a:ext cx="1280160" cy="406265"/>
          </a:xfrm>
          <a:prstGeom prst="rect">
            <a:avLst/>
          </a:prstGeom>
          <a:noFill/>
          <a:ln>
            <a:solidFill>
              <a:srgbClr val="FFFFFF">
                <a:lumMod val="65000"/>
              </a:srgbClr>
            </a:solidFill>
          </a:ln>
        </p:spPr>
        <p:txBody>
          <a:bodyPr wrap="none" lIns="45720" tIns="18288" rIns="45720" bIns="18288" anchor="ctr" anchorCtr="0">
            <a:noAutofit/>
          </a:bodyPr>
          <a:lstStyle/>
          <a:p>
            <a:pPr marL="3143250" marR="0" lvl="0" indent="-314325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0" cap="none" spc="0" normalizeH="0" baseline="0" noProof="0" dirty="0">
                <a:ln>
                  <a:noFill/>
                </a:ln>
                <a:solidFill>
                  <a:srgbClr val="00B050"/>
                </a:solidFill>
                <a:effectLst/>
                <a:uLnTx/>
                <a:uFillTx/>
                <a:latin typeface="Arial"/>
                <a:ea typeface="宋体" panose="02010600030101010101" pitchFamily="2" charset="-122"/>
              </a:rPr>
              <a:t>This study</a:t>
            </a:r>
          </a:p>
          <a:p>
            <a:pPr marL="3143250" marR="0" lvl="0" indent="-314325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0" dirty="0">
                <a:solidFill>
                  <a:srgbClr val="00B050"/>
                </a:solidFill>
                <a:latin typeface="Arial"/>
                <a:ea typeface="宋体" panose="02010600030101010101" pitchFamily="2" charset="-122"/>
              </a:rPr>
              <a:t>2023</a:t>
            </a:r>
            <a:endParaRPr kumimoji="0" lang="en-US" sz="1200" b="0" u="none" strike="noStrike" kern="0" cap="none" spc="0" normalizeH="0" baseline="0" noProof="0" dirty="0">
              <a:ln>
                <a:noFill/>
              </a:ln>
              <a:solidFill>
                <a:srgbClr val="00B050"/>
              </a:solidFill>
              <a:effectLst/>
              <a:uLnTx/>
              <a:uFillTx/>
              <a:latin typeface="Arial"/>
              <a:ea typeface="宋体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3053080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216</TotalTime>
  <Words>247</Words>
  <Application>Microsoft Office PowerPoint</Application>
  <PresentationFormat>On-screen Show (4:3)</PresentationFormat>
  <Paragraphs>4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dentification of New Ehrlichia chaffeensis Antigens   1/20/2021</dc:title>
  <dc:creator>T Luo</dc:creator>
  <cp:lastModifiedBy>Luo, Tian</cp:lastModifiedBy>
  <cp:revision>102</cp:revision>
  <cp:lastPrinted>2023-08-23T22:41:46Z</cp:lastPrinted>
  <dcterms:created xsi:type="dcterms:W3CDTF">2021-01-20T17:01:12Z</dcterms:created>
  <dcterms:modified xsi:type="dcterms:W3CDTF">2023-08-25T15:53:11Z</dcterms:modified>
</cp:coreProperties>
</file>